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29" r:id="rId2"/>
    <p:sldId id="530" r:id="rId3"/>
    <p:sldId id="272" r:id="rId4"/>
    <p:sldId id="461" r:id="rId5"/>
    <p:sldId id="279" r:id="rId6"/>
    <p:sldId id="278" r:id="rId7"/>
    <p:sldId id="492" r:id="rId8"/>
    <p:sldId id="258" r:id="rId9"/>
    <p:sldId id="282" r:id="rId10"/>
    <p:sldId id="459" r:id="rId11"/>
    <p:sldId id="464" r:id="rId12"/>
    <p:sldId id="465" r:id="rId13"/>
    <p:sldId id="489" r:id="rId14"/>
    <p:sldId id="476" r:id="rId15"/>
    <p:sldId id="512" r:id="rId16"/>
    <p:sldId id="523" r:id="rId17"/>
    <p:sldId id="257" r:id="rId18"/>
    <p:sldId id="513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Natrosol 0.5 %, bid</c:v>
          </c:tx>
          <c:spPr>
            <a:ln w="12700">
              <a:solidFill>
                <a:schemeClr val="bg1">
                  <a:lumMod val="50000"/>
                </a:schemeClr>
              </a:solidFill>
              <a:prstDash val="solid"/>
            </a:ln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  <a:prstDash val="solid"/>
              </a:ln>
            </c:spPr>
          </c:marker>
          <c:xVal>
            <c:numRef>
              <c:f>'TV Data'!$B$2:$I$2</c:f>
              <c:numCache>
                <c:formatCode>General</c:formatCode>
                <c:ptCount val="8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</c:numCache>
            </c:numRef>
          </c:xVal>
          <c:yVal>
            <c:numRef>
              <c:f>'TV Data'!$B$22:$I$22</c:f>
              <c:numCache>
                <c:formatCode>General</c:formatCode>
                <c:ptCount val="8"/>
                <c:pt idx="0">
                  <c:v>115.04</c:v>
                </c:pt>
                <c:pt idx="1">
                  <c:v>148.88999999999999</c:v>
                </c:pt>
                <c:pt idx="2">
                  <c:v>278.92</c:v>
                </c:pt>
                <c:pt idx="3">
                  <c:v>378.55</c:v>
                </c:pt>
                <c:pt idx="4">
                  <c:v>466.14</c:v>
                </c:pt>
                <c:pt idx="5">
                  <c:v>357.18</c:v>
                </c:pt>
                <c:pt idx="6">
                  <c:v>621.01</c:v>
                </c:pt>
                <c:pt idx="7">
                  <c:v>717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134-4D96-9AA9-421306532B2D}"/>
            </c:ext>
          </c:extLst>
        </c:ser>
        <c:ser>
          <c:idx val="1"/>
          <c:order val="1"/>
          <c:tx>
            <c:v>BI00894999, 2 mg/kg, bid, qd</c:v>
          </c:tx>
          <c:spPr>
            <a:ln w="12700">
              <a:solidFill>
                <a:srgbClr val="00FF00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00FF00"/>
              </a:solidFill>
              <a:ln>
                <a:solidFill>
                  <a:srgbClr val="00FF00"/>
                </a:solidFill>
                <a:prstDash val="solid"/>
              </a:ln>
            </c:spPr>
          </c:marker>
          <c:xVal>
            <c:numRef>
              <c:f>'TV Data'!$B$2:$I$2</c:f>
              <c:numCache>
                <c:formatCode>General</c:formatCode>
                <c:ptCount val="8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</c:numCache>
            </c:numRef>
          </c:xVal>
          <c:yVal>
            <c:numRef>
              <c:f>'TV Data'!$B$23:$I$23</c:f>
              <c:numCache>
                <c:formatCode>General</c:formatCode>
                <c:ptCount val="8"/>
                <c:pt idx="0">
                  <c:v>117</c:v>
                </c:pt>
                <c:pt idx="1">
                  <c:v>136.07</c:v>
                </c:pt>
                <c:pt idx="2">
                  <c:v>156.68</c:v>
                </c:pt>
                <c:pt idx="3">
                  <c:v>180.6</c:v>
                </c:pt>
                <c:pt idx="4">
                  <c:v>212.58</c:v>
                </c:pt>
                <c:pt idx="5">
                  <c:v>188.83</c:v>
                </c:pt>
                <c:pt idx="6">
                  <c:v>307.95999999999998</c:v>
                </c:pt>
                <c:pt idx="7">
                  <c:v>389.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134-4D96-9AA9-421306532B2D}"/>
            </c:ext>
          </c:extLst>
        </c:ser>
        <c:ser>
          <c:idx val="2"/>
          <c:order val="2"/>
          <c:tx>
            <c:v>BI00894999, 4 mg/kg, qd</c:v>
          </c:tx>
          <c:spPr>
            <a:ln w="12700">
              <a:solidFill>
                <a:srgbClr val="0000FF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0000FF"/>
              </a:solidFill>
              <a:ln>
                <a:solidFill>
                  <a:srgbClr val="0000FF"/>
                </a:solidFill>
                <a:prstDash val="solid"/>
              </a:ln>
            </c:spPr>
          </c:marker>
          <c:xVal>
            <c:numRef>
              <c:f>'TV Data'!$B$2:$I$2</c:f>
              <c:numCache>
                <c:formatCode>General</c:formatCode>
                <c:ptCount val="8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</c:numCache>
            </c:numRef>
          </c:xVal>
          <c:yVal>
            <c:numRef>
              <c:f>'TV Data'!$B$24:$I$24</c:f>
              <c:numCache>
                <c:formatCode>General</c:formatCode>
                <c:ptCount val="8"/>
                <c:pt idx="0">
                  <c:v>124.03</c:v>
                </c:pt>
                <c:pt idx="1">
                  <c:v>140.18</c:v>
                </c:pt>
                <c:pt idx="2">
                  <c:v>166.45</c:v>
                </c:pt>
                <c:pt idx="3">
                  <c:v>149.09</c:v>
                </c:pt>
                <c:pt idx="4">
                  <c:v>147.35</c:v>
                </c:pt>
                <c:pt idx="5">
                  <c:v>139.66999999999999</c:v>
                </c:pt>
                <c:pt idx="6">
                  <c:v>215.46</c:v>
                </c:pt>
                <c:pt idx="7">
                  <c:v>343.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134-4D96-9AA9-421306532B2D}"/>
            </c:ext>
          </c:extLst>
        </c:ser>
        <c:ser>
          <c:idx val="3"/>
          <c:order val="3"/>
          <c:tx>
            <c:v>BI00894999, 12 mg/kg, qd_x000d_
BI00894999, 8 mg/kg, qd</c:v>
          </c:tx>
          <c:spPr>
            <a:ln w="12700">
              <a:solidFill>
                <a:srgbClr val="C00000"/>
              </a:solidFill>
              <a:prstDash val="solid"/>
            </a:ln>
          </c:spPr>
          <c:marker>
            <c:symbol val="x"/>
            <c:size val="5"/>
            <c:spPr>
              <a:solidFill>
                <a:srgbClr val="C00000"/>
              </a:solidFill>
              <a:ln>
                <a:solidFill>
                  <a:srgbClr val="C00000"/>
                </a:solidFill>
                <a:prstDash val="solid"/>
              </a:ln>
            </c:spPr>
          </c:marker>
          <c:xVal>
            <c:numRef>
              <c:f>'TV Data'!$B$2:$I$2</c:f>
              <c:numCache>
                <c:formatCode>General</c:formatCode>
                <c:ptCount val="8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</c:numCache>
            </c:numRef>
          </c:xVal>
          <c:yVal>
            <c:numRef>
              <c:f>'TV Data'!$B$25:$I$25</c:f>
              <c:numCache>
                <c:formatCode>General</c:formatCode>
                <c:ptCount val="8"/>
                <c:pt idx="0">
                  <c:v>120.76</c:v>
                </c:pt>
                <c:pt idx="1">
                  <c:v>117.35</c:v>
                </c:pt>
                <c:pt idx="2">
                  <c:v>117.19</c:v>
                </c:pt>
                <c:pt idx="3">
                  <c:v>67.52</c:v>
                </c:pt>
                <c:pt idx="4">
                  <c:v>78.760000000000005</c:v>
                </c:pt>
                <c:pt idx="5">
                  <c:v>76.94</c:v>
                </c:pt>
                <c:pt idx="6">
                  <c:v>93.8</c:v>
                </c:pt>
                <c:pt idx="7">
                  <c:v>128.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134-4D96-9AA9-421306532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5284352"/>
        <c:axId val="215295104"/>
      </c:scatterChart>
      <c:valAx>
        <c:axId val="215284352"/>
        <c:scaling>
          <c:orientation val="minMax"/>
          <c:max val="1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/>
                  <a:t>Day</a:t>
                </a:r>
              </a:p>
            </c:rich>
          </c:tx>
          <c:layout>
            <c:manualLayout>
              <c:xMode val="edge"/>
              <c:yMode val="edge"/>
              <c:x val="0.52528891698153468"/>
              <c:y val="0.9102117209820458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215295104"/>
        <c:crossesAt val="0"/>
        <c:crossBetween val="midCat"/>
        <c:majorUnit val="2"/>
      </c:valAx>
      <c:valAx>
        <c:axId val="215295104"/>
        <c:scaling>
          <c:orientation val="minMax"/>
          <c:max val="800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900"/>
                </a:pPr>
                <a:r>
                  <a:rPr lang="en-US"/>
                  <a:t>Median Tumor Volume [mm</a:t>
                </a:r>
                <a:r>
                  <a:rPr lang="en-US" baseline="30000"/>
                  <a:t>3</a:t>
                </a:r>
                <a:r>
                  <a:rPr lang="en-US"/>
                  <a:t>]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21528435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 w="9525">
      <a:noFill/>
    </a:ln>
  </c:spPr>
  <c:externalData r:id="rId2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3EBCF-4F97-46B4-BF06-65751E58E8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6C56A8-4714-49D2-A619-F526F6D21A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B34F5-DC46-4FEB-971E-DD49E69C7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331BA-F66A-4D9B-9534-7C496529C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72DE1B-F47E-4E4C-AB25-1A9A4909A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650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29F5C-17C7-4B8B-88ED-05CAC0D8AA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D31A60-88D9-4000-802D-9CB3F45258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FCFF4-0B0C-4E36-917F-481319FA7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5F7ED9-98FC-472A-9D2F-1FBC5A1B3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F16D2C-4BFB-4360-BC33-9BE082903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203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9F1728-FB48-4148-A2AC-757BC32679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858FE7-5433-4AFE-B9CA-6CB7F4286E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CF2503-43D8-4ADB-B794-D0405C564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09691-C43A-4402-89E5-47733AE22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14D357-17F7-4CDB-8A06-51BABF2B4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947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4B4A99-7B77-4A7F-AE54-498D8230D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83B94E-F663-438D-96C4-A7B38B9FF5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05BE28-A149-483A-8282-AD5E25A12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AF9247-7B37-48FE-9B07-B671DE84E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A43022-2003-4D42-9A75-64CD487DD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302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61DCF-21A2-499C-9144-7E8FB36492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2BF6C1-BED1-4781-B885-E38463FF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F0BD8C-B7F5-41CE-BFFA-A4145D003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8608AF-D7F8-4950-8E03-29CD3B7D5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9DB60A-12E0-4AB7-B56F-528956759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170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A0E67-54BC-4431-ACFA-56372A7DA9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1E7310-EEA1-461B-8A70-4EE3583DA1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AC587D-0665-415A-AF31-727AF490A0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7BA591-47DD-44C2-97B5-005999414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DF0E6D-DFC0-4251-B197-DEEEE578E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1565A2-EB02-4B99-9530-5F4B1C56A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983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BE7B7-2BD2-4C71-82A6-811A1F0FC6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75FBEA-EB27-4D4C-BD2F-F3E2AAD6E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722012-C099-46E6-8F27-E5719E4289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474020-F7C4-4930-95B2-1D46024A16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4C4AA7-E24D-4260-9222-108B50442E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472E7A-F783-4DEA-BF56-00A838D0E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BB19BD3-EAC2-4CCB-8C95-815F9A278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6D41E0-3228-4DC9-8D15-06C9558B3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903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48298A-EA24-4E16-91F6-1CFFC447F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613C157-A78C-46BB-949F-97FB6552B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AADBD7-CA61-4024-A8C6-33B109A2B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27B4B4-C684-40BA-91AA-BA8A3E83C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237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E1E55F-78D8-43CA-BA11-500CB6570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A59A10-B7E6-432C-89FB-320DE20BD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91BE76-3FBD-470E-9227-BF12DFA0A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67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9AF96-46DF-4E03-B8D2-970696D3B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1BC10B-4B28-43F1-92F1-D766964362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493B4E-93F3-4A97-9C09-627CA729C5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A9D9FB-DD9B-44EA-8A14-C8B47C559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7A5ACA-9191-45B2-A0CB-F1210E531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F4D01C-9917-4F75-8A8C-469B987B8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782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72975-FEE9-4A6E-B076-5AE61BF7D8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EF35F9-B928-47CB-9B60-66FD50D4A3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DB1B0B-AD53-43B3-8A2B-3B43D457C0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14E7CD-FABE-4FF5-BC88-B7CA420A4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224262-1488-469B-8CE5-83B4B5A60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7532ED-1D2B-4973-9A3F-454737822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857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1763FA-6F67-425F-B436-BCFE1E5AA6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6D85BA-0C66-49C7-8451-D100C069A2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28F5C9-0CE4-4063-ABDB-D8CB98D97C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2C075-88DA-46BA-9D7F-83365F8A30F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32193C-EE82-45A6-BCF9-DE41B264BC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FACFE-6FBC-41CC-BDBA-72BEED3952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D4AE7-E923-4CC9-9030-D508A450FD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898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5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6.emf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3" Type="http://schemas.microsoft.com/office/2007/relationships/hdphoto" Target="../media/hdphoto21.wdp"/><Relationship Id="rId7" Type="http://schemas.microsoft.com/office/2007/relationships/hdphoto" Target="../media/hdphoto23.wdp"/><Relationship Id="rId12" Type="http://schemas.openxmlformats.org/officeDocument/2006/relationships/image" Target="../media/image5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microsoft.com/office/2007/relationships/hdphoto" Target="../media/hdphoto25.wdp"/><Relationship Id="rId5" Type="http://schemas.microsoft.com/office/2007/relationships/hdphoto" Target="../media/hdphoto22.wdp"/><Relationship Id="rId10" Type="http://schemas.openxmlformats.org/officeDocument/2006/relationships/image" Target="../media/image51.png"/><Relationship Id="rId4" Type="http://schemas.openxmlformats.org/officeDocument/2006/relationships/image" Target="../media/image48.png"/><Relationship Id="rId9" Type="http://schemas.microsoft.com/office/2007/relationships/hdphoto" Target="../media/hdphoto24.wdp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microsoft.com/office/2007/relationships/hdphoto" Target="../media/hdphoto2.wdp"/><Relationship Id="rId4" Type="http://schemas.openxmlformats.org/officeDocument/2006/relationships/image" Target="../media/image12.png"/><Relationship Id="rId9" Type="http://schemas.microsoft.com/office/2007/relationships/hdphoto" Target="../media/hdphoto4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microsoft.com/office/2007/relationships/hdphoto" Target="../media/hdphoto6.wdp"/><Relationship Id="rId4" Type="http://schemas.openxmlformats.org/officeDocument/2006/relationships/image" Target="../media/image16.png"/><Relationship Id="rId9" Type="http://schemas.microsoft.com/office/2007/relationships/hdphoto" Target="../media/hdphoto8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microsoft.com/office/2007/relationships/hdphoto" Target="../media/hdphoto9.wdp"/><Relationship Id="rId7" Type="http://schemas.microsoft.com/office/2007/relationships/hdphoto" Target="../media/hdphoto11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5" Type="http://schemas.microsoft.com/office/2007/relationships/hdphoto" Target="../media/hdphoto10.wdp"/><Relationship Id="rId4" Type="http://schemas.openxmlformats.org/officeDocument/2006/relationships/image" Target="../media/image20.png"/><Relationship Id="rId9" Type="http://schemas.microsoft.com/office/2007/relationships/hdphoto" Target="../media/hdphoto12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microsoft.com/office/2007/relationships/hdphoto" Target="../media/hdphoto13.wdp"/><Relationship Id="rId7" Type="http://schemas.microsoft.com/office/2007/relationships/hdphoto" Target="../media/hdphoto15.wdp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5" Type="http://schemas.microsoft.com/office/2007/relationships/hdphoto" Target="../media/hdphoto14.wdp"/><Relationship Id="rId4" Type="http://schemas.openxmlformats.org/officeDocument/2006/relationships/image" Target="../media/image24.png"/><Relationship Id="rId9" Type="http://schemas.microsoft.com/office/2007/relationships/hdphoto" Target="../media/hdphoto16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microsoft.com/office/2007/relationships/hdphoto" Target="../media/hdphoto17.wdp"/><Relationship Id="rId7" Type="http://schemas.microsoft.com/office/2007/relationships/hdphoto" Target="../media/hdphoto19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microsoft.com/office/2007/relationships/hdphoto" Target="../media/hdphoto18.wdp"/><Relationship Id="rId4" Type="http://schemas.openxmlformats.org/officeDocument/2006/relationships/image" Target="../media/image28.png"/><Relationship Id="rId9" Type="http://schemas.microsoft.com/office/2007/relationships/hdphoto" Target="../media/hdphoto20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8AC1A08-A9EF-45CD-B7CA-5E6879F805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201" y="2022860"/>
            <a:ext cx="2711758" cy="20338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B29257-27EB-4353-BA31-D062FFF6B300}"/>
              </a:ext>
            </a:extLst>
          </p:cNvPr>
          <p:cNvSpPr txBox="1"/>
          <p:nvPr/>
        </p:nvSpPr>
        <p:spPr>
          <a:xfrm>
            <a:off x="553689" y="1766335"/>
            <a:ext cx="23774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Ty-82: BI 894999: GI</a:t>
            </a:r>
            <a:r>
              <a:rPr lang="de-AT" sz="1400" baseline="-25000" dirty="0"/>
              <a:t>50</a:t>
            </a:r>
            <a:r>
              <a:rPr lang="de-AT" sz="1400" dirty="0"/>
              <a:t>=2.2 nM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D81B1A-CB65-4FA4-B39A-46AD3DAF7073}"/>
              </a:ext>
            </a:extLst>
          </p:cNvPr>
          <p:cNvSpPr txBox="1"/>
          <p:nvPr/>
        </p:nvSpPr>
        <p:spPr>
          <a:xfrm>
            <a:off x="3265447" y="1737556"/>
            <a:ext cx="23984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10-15: BI 894999: GI</a:t>
            </a:r>
            <a:r>
              <a:rPr lang="de-AT" sz="1400" baseline="-25000" dirty="0"/>
              <a:t>50</a:t>
            </a:r>
            <a:r>
              <a:rPr lang="de-AT" sz="1400" dirty="0"/>
              <a:t>=2.3 nM</a:t>
            </a:r>
            <a:endParaRPr lang="en-US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946067F-5A95-4C6A-9D97-842409E0EC66}"/>
              </a:ext>
            </a:extLst>
          </p:cNvPr>
          <p:cNvSpPr txBox="1"/>
          <p:nvPr/>
        </p:nvSpPr>
        <p:spPr>
          <a:xfrm>
            <a:off x="5946649" y="1760388"/>
            <a:ext cx="2435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14169: BI 894999: GI</a:t>
            </a:r>
            <a:r>
              <a:rPr lang="de-AT" sz="1400" baseline="-25000" dirty="0"/>
              <a:t>50</a:t>
            </a:r>
            <a:r>
              <a:rPr lang="de-AT" sz="1400" dirty="0"/>
              <a:t>=1.2 nM</a:t>
            </a:r>
            <a:endParaRPr lang="en-US" sz="1400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F09594FD-04F4-411A-8CF9-0DF3AF9A67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78573" y="1817063"/>
            <a:ext cx="3222530" cy="241689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799C30F1-2F9B-4638-AC98-C6B9B86681B2}"/>
              </a:ext>
            </a:extLst>
          </p:cNvPr>
          <p:cNvSpPr txBox="1"/>
          <p:nvPr/>
        </p:nvSpPr>
        <p:spPr>
          <a:xfrm>
            <a:off x="8845052" y="1760388"/>
            <a:ext cx="2435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10326: BI 894999: GI</a:t>
            </a:r>
            <a:r>
              <a:rPr lang="de-AT" sz="1400" baseline="-25000" dirty="0"/>
              <a:t>50</a:t>
            </a:r>
            <a:r>
              <a:rPr lang="de-AT" sz="1400" dirty="0"/>
              <a:t>=1.1 nM</a:t>
            </a:r>
            <a:endParaRPr lang="en-US" sz="1400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23B407E3-D714-47FA-85BB-316B65A519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04500" y="2022860"/>
            <a:ext cx="2848607" cy="213645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CF11A65-4AF2-4DAD-B2FE-42BB271B4E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9959" y="2022860"/>
            <a:ext cx="2848607" cy="213645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1821E11-1816-4E0F-A62D-80246EFB1866}"/>
              </a:ext>
            </a:extLst>
          </p:cNvPr>
          <p:cNvSpPr txBox="1"/>
          <p:nvPr/>
        </p:nvSpPr>
        <p:spPr>
          <a:xfrm>
            <a:off x="490099" y="212368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1</a:t>
            </a:r>
          </a:p>
        </p:txBody>
      </p:sp>
    </p:spTree>
    <p:extLst>
      <p:ext uri="{BB962C8B-B14F-4D97-AF65-F5344CB8AC3E}">
        <p14:creationId xmlns:p14="http://schemas.microsoft.com/office/powerpoint/2010/main" val="38798371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1">
            <a:extLst>
              <a:ext uri="{FF2B5EF4-FFF2-40B4-BE49-F238E27FC236}">
                <a16:creationId xmlns:a16="http://schemas.microsoft.com/office/drawing/2014/main" id="{9E981ABD-1209-40E7-9878-C5F13E1130C6}"/>
              </a:ext>
            </a:extLst>
          </p:cNvPr>
          <p:cNvSpPr txBox="1">
            <a:spLocks/>
          </p:cNvSpPr>
          <p:nvPr/>
        </p:nvSpPr>
        <p:spPr>
          <a:xfrm>
            <a:off x="6982702" y="1476185"/>
            <a:ext cx="2704909" cy="1961557"/>
          </a:xfrm>
          <a:prstGeom prst="rect">
            <a:avLst/>
          </a:prstGeom>
          <a:noFill/>
        </p:spPr>
        <p:txBody>
          <a:bodyPr/>
          <a:lstStyle>
            <a:lvl1pPr marL="266700" indent="-266700" algn="l" defTabSz="914400" rtl="0" eaLnBrk="1" latinLnBrk="0" hangingPunct="1">
              <a:spcBef>
                <a:spcPts val="4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BISansOpti"/>
                <a:ea typeface="+mn-ea"/>
                <a:cs typeface="BISansOpti"/>
              </a:defRPr>
            </a:lvl1pPr>
            <a:lvl2pPr marL="450850" indent="-184150" algn="l" defTabSz="914400" rtl="0" eaLnBrk="1" latinLnBrk="0" hangingPunct="1">
              <a:spcBef>
                <a:spcPts val="0"/>
              </a:spcBef>
              <a:buFont typeface="Arial" panose="020B0604020202020204" pitchFamily="34" charset="0"/>
              <a:buChar char="–"/>
              <a:defRPr sz="1600" kern="1200">
                <a:solidFill>
                  <a:schemeClr val="tx1"/>
                </a:solidFill>
                <a:latin typeface="BISansOpti"/>
                <a:ea typeface="+mn-ea"/>
                <a:cs typeface="BISansOpti"/>
              </a:defRPr>
            </a:lvl2pPr>
            <a:lvl3pPr marL="628650" indent="-177800" algn="l" defTabSz="914400" rtl="0" eaLnBrk="1" latinLnBrk="0" hangingPunct="1">
              <a:spcBef>
                <a:spcPts val="0"/>
              </a:spcBef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BISansOpti"/>
                <a:ea typeface="+mn-ea"/>
                <a:cs typeface="BISansOpti"/>
              </a:defRPr>
            </a:lvl3pPr>
            <a:lvl4pPr marL="806450" indent="-177800" algn="l" defTabSz="914400" rtl="0" eaLnBrk="1" latinLnBrk="0" hangingPunct="1">
              <a:spcBef>
                <a:spcPts val="0"/>
              </a:spcBef>
              <a:buFont typeface="Arial" panose="020B0604020202020204" pitchFamily="34" charset="0"/>
              <a:buChar char="–"/>
              <a:defRPr sz="1600" kern="1200">
                <a:solidFill>
                  <a:schemeClr val="tx1"/>
                </a:solidFill>
                <a:latin typeface="BISansOpti"/>
                <a:ea typeface="+mn-ea"/>
                <a:cs typeface="BISansOpti"/>
              </a:defRPr>
            </a:lvl4pPr>
            <a:lvl5pPr marL="984250" indent="-177800" algn="l" defTabSz="914400" rtl="0" eaLnBrk="1" latinLnBrk="0" hangingPunct="1">
              <a:spcBef>
                <a:spcPts val="0"/>
              </a:spcBef>
              <a:buFont typeface="Wingdings" panose="05000000000000000000" pitchFamily="2" charset="2"/>
              <a:buChar char="§"/>
              <a:defRPr sz="1600" kern="1200">
                <a:solidFill>
                  <a:schemeClr val="tx1"/>
                </a:solidFill>
                <a:latin typeface="BISansOpti"/>
                <a:ea typeface="+mn-ea"/>
                <a:cs typeface="BISansOpti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GB" sz="1400" dirty="0"/>
              <a:t>Accumulative dose of 6 weeks for different schedules </a:t>
            </a:r>
          </a:p>
          <a:p>
            <a:r>
              <a:rPr lang="en-GB" sz="1400" dirty="0">
                <a:solidFill>
                  <a:srgbClr val="FF0000"/>
                </a:solidFill>
              </a:rPr>
              <a:t>SchB-2.5mg : 70mg</a:t>
            </a:r>
          </a:p>
          <a:p>
            <a:r>
              <a:rPr lang="en-GB" sz="1400" dirty="0">
                <a:solidFill>
                  <a:srgbClr val="92D050"/>
                </a:solidFill>
              </a:rPr>
              <a:t>SchC-5/2.5mg: 60mg</a:t>
            </a:r>
          </a:p>
          <a:p>
            <a:r>
              <a:rPr lang="en-GB" sz="14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SchC-6/3mg: 72mg</a:t>
            </a:r>
          </a:p>
          <a:p>
            <a:r>
              <a:rPr lang="en-GB" sz="1400" dirty="0">
                <a:solidFill>
                  <a:srgbClr val="7030A0"/>
                </a:solidFill>
              </a:rPr>
              <a:t>SchC-7/3.5mg: 84mg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4225F0E-EA33-4AB9-B3F9-75BD754A1676}"/>
              </a:ext>
            </a:extLst>
          </p:cNvPr>
          <p:cNvSpPr txBox="1"/>
          <p:nvPr/>
        </p:nvSpPr>
        <p:spPr>
          <a:xfrm>
            <a:off x="1059783" y="964982"/>
            <a:ext cx="456818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de-AT" sz="1200" dirty="0"/>
              <a:t>Pharmacometrics </a:t>
            </a:r>
            <a:r>
              <a:rPr lang="de-AT" sz="1200" dirty="0" err="1"/>
              <a:t>modeling</a:t>
            </a:r>
            <a:r>
              <a:rPr lang="de-AT" sz="1200" dirty="0"/>
              <a:t> </a:t>
            </a:r>
            <a:r>
              <a:rPr lang="de-AT" sz="1200" dirty="0" err="1"/>
              <a:t>led</a:t>
            </a:r>
            <a:r>
              <a:rPr lang="de-AT" sz="1200" dirty="0"/>
              <a:t> </a:t>
            </a:r>
            <a:r>
              <a:rPr lang="de-AT" sz="1200" dirty="0" err="1"/>
              <a:t>to</a:t>
            </a:r>
            <a:r>
              <a:rPr lang="de-AT" sz="1200" dirty="0"/>
              <a:t> </a:t>
            </a:r>
            <a:r>
              <a:rPr lang="de-AT" sz="1200" dirty="0" err="1"/>
              <a:t>proposal</a:t>
            </a:r>
            <a:r>
              <a:rPr lang="de-AT" sz="1200" dirty="0"/>
              <a:t> </a:t>
            </a:r>
            <a:r>
              <a:rPr lang="de-AT" sz="1200" dirty="0" err="1"/>
              <a:t>of</a:t>
            </a:r>
            <a:r>
              <a:rPr lang="de-AT" sz="1200" dirty="0"/>
              <a:t> Schedule 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890364-18D5-4391-AC09-138A37B5032F}"/>
              </a:ext>
            </a:extLst>
          </p:cNvPr>
          <p:cNvSpPr txBox="1"/>
          <p:nvPr/>
        </p:nvSpPr>
        <p:spPr>
          <a:xfrm>
            <a:off x="251180" y="173931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6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CA1E01A-F3A6-46FA-B1DB-17E9D387B89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162" r="16245"/>
          <a:stretch/>
        </p:blipFill>
        <p:spPr>
          <a:xfrm>
            <a:off x="968302" y="838936"/>
            <a:ext cx="5838322" cy="2771674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A6A2F5AB-26E5-4803-A58C-CC7A3AF0D75B}"/>
              </a:ext>
            </a:extLst>
          </p:cNvPr>
          <p:cNvGrpSpPr/>
          <p:nvPr/>
        </p:nvGrpSpPr>
        <p:grpSpPr>
          <a:xfrm>
            <a:off x="909468" y="3639167"/>
            <a:ext cx="5843870" cy="2703960"/>
            <a:chOff x="566568" y="3420092"/>
            <a:chExt cx="5843870" cy="270396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5BB2231-B012-4D46-92EE-BD3573E956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033" r="16886"/>
            <a:stretch/>
          </p:blipFill>
          <p:spPr>
            <a:xfrm>
              <a:off x="616281" y="3420092"/>
              <a:ext cx="5794157" cy="270396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CF9C3A2-2A47-4E42-9056-5B70FAD7221B}"/>
                </a:ext>
              </a:extLst>
            </p:cNvPr>
            <p:cNvSpPr txBox="1"/>
            <p:nvPr/>
          </p:nvSpPr>
          <p:spPr>
            <a:xfrm rot="16200000">
              <a:off x="-237460" y="4488387"/>
              <a:ext cx="176194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de-AT" sz="1000" dirty="0"/>
                <a:t>    Plasma </a:t>
              </a:r>
              <a:r>
                <a:rPr lang="de-AT" sz="1000" dirty="0" err="1"/>
                <a:t>Concentration</a:t>
              </a:r>
              <a:r>
                <a:rPr lang="de-AT" sz="1000" dirty="0"/>
                <a:t> (</a:t>
              </a:r>
              <a:r>
                <a:rPr lang="de-AT" sz="1000" dirty="0" err="1"/>
                <a:t>nM</a:t>
              </a:r>
              <a:r>
                <a:rPr lang="de-AT" sz="1000" dirty="0"/>
                <a:t>)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9E138636-B234-4654-B4DC-ACC895700845}"/>
              </a:ext>
            </a:extLst>
          </p:cNvPr>
          <p:cNvSpPr txBox="1"/>
          <p:nvPr/>
        </p:nvSpPr>
        <p:spPr>
          <a:xfrm rot="16200000">
            <a:off x="369256" y="2267318"/>
            <a:ext cx="1234312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de-AT" sz="1000" dirty="0" err="1"/>
              <a:t>Platelet</a:t>
            </a:r>
            <a:r>
              <a:rPr lang="de-AT" sz="1000" dirty="0"/>
              <a:t> Counts(10^9/L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B67E202-D74B-41D8-92AE-E0EBBEB9361B}"/>
              </a:ext>
            </a:extLst>
          </p:cNvPr>
          <p:cNvSpPr txBox="1"/>
          <p:nvPr/>
        </p:nvSpPr>
        <p:spPr>
          <a:xfrm>
            <a:off x="3642976" y="6266183"/>
            <a:ext cx="1402666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de-AT" sz="1000" dirty="0"/>
              <a:t>Time (</a:t>
            </a:r>
            <a:r>
              <a:rPr lang="de-AT" sz="1000" dirty="0" err="1"/>
              <a:t>days</a:t>
            </a:r>
            <a:r>
              <a:rPr lang="de-AT" sz="1000" dirty="0"/>
              <a:t>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A96703C-ADD8-4659-8F8B-8260737EDA52}"/>
              </a:ext>
            </a:extLst>
          </p:cNvPr>
          <p:cNvGrpSpPr/>
          <p:nvPr/>
        </p:nvGrpSpPr>
        <p:grpSpPr>
          <a:xfrm>
            <a:off x="1185635" y="3938903"/>
            <a:ext cx="5987502" cy="152440"/>
            <a:chOff x="228600" y="4775428"/>
            <a:chExt cx="6669024" cy="193899"/>
          </a:xfrm>
        </p:grpSpPr>
        <p:sp>
          <p:nvSpPr>
            <p:cNvPr id="13" name="Content Placeholder 10">
              <a:extLst>
                <a:ext uri="{FF2B5EF4-FFF2-40B4-BE49-F238E27FC236}">
                  <a16:creationId xmlns:a16="http://schemas.microsoft.com/office/drawing/2014/main" id="{E1017BE1-6101-427B-833B-F1F2420B2DC0}"/>
                </a:ext>
              </a:extLst>
            </p:cNvPr>
            <p:cNvSpPr txBox="1">
              <a:spLocks/>
            </p:cNvSpPr>
            <p:nvPr/>
          </p:nvSpPr>
          <p:spPr>
            <a:xfrm>
              <a:off x="5468112" y="4775428"/>
              <a:ext cx="1429512" cy="184975"/>
            </a:xfrm>
            <a:prstGeom prst="rect">
              <a:avLst/>
            </a:prstGeom>
            <a:ln w="12700">
              <a:noFill/>
            </a:ln>
          </p:spPr>
          <p:txBody>
            <a:bodyPr vert="horz" wrap="square" lIns="0" tIns="0" rIns="0" bIns="0" rtlCol="0">
              <a:spAutoFit/>
            </a:bodyPr>
            <a:lstStyle>
              <a:lvl1pPr marL="170260" indent="-170260" algn="l" defTabSz="685800" rtl="0" eaLnBrk="1" latinLnBrk="0" hangingPunct="1">
                <a:lnSpc>
                  <a:spcPct val="90000"/>
                </a:lnSpc>
                <a:spcBef>
                  <a:spcPts val="450"/>
                </a:spcBef>
                <a:spcAft>
                  <a:spcPts val="450"/>
                </a:spcAft>
                <a:buClr>
                  <a:schemeClr val="accent4"/>
                </a:buClr>
                <a:buFont typeface="Arial" panose="020B0604020202020204" pitchFamily="34" charset="0"/>
                <a:buChar char="•"/>
                <a:defRPr sz="1350" b="0" i="0" kern="1200" baseline="0">
                  <a:solidFill>
                    <a:schemeClr val="tx1"/>
                  </a:solidFill>
                  <a:latin typeface="+mn-lt"/>
                  <a:ea typeface="+mn-ea"/>
                  <a:cs typeface="Arial" pitchFamily="34" charset="0"/>
                </a:defRPr>
              </a:lvl1pPr>
              <a:lvl2pPr marL="344091" indent="-173831" algn="l" defTabSz="685800" rtl="0" eaLnBrk="1" latinLnBrk="0" hangingPunct="1">
                <a:lnSpc>
                  <a:spcPct val="90000"/>
                </a:lnSpc>
                <a:spcBef>
                  <a:spcPts val="0"/>
                </a:spcBef>
                <a:spcAft>
                  <a:spcPts val="450"/>
                </a:spcAft>
                <a:buClr>
                  <a:schemeClr val="accent4"/>
                </a:buClr>
                <a:buSzPct val="85000"/>
                <a:buFont typeface="Arial" pitchFamily="34" charset="0"/>
                <a:buChar char="–"/>
                <a:tabLst/>
                <a:defRPr sz="1200" kern="1200">
                  <a:solidFill>
                    <a:schemeClr val="tx1"/>
                  </a:solidFill>
                  <a:latin typeface="+mn-lt"/>
                  <a:ea typeface="+mn-ea"/>
                  <a:cs typeface="Arial" pitchFamily="34" charset="0"/>
                </a:defRPr>
              </a:lvl2pPr>
              <a:lvl3pPr marL="515541" indent="-171450" algn="l" defTabSz="685800" rtl="0" eaLnBrk="1" latinLnBrk="0" hangingPunct="1">
                <a:lnSpc>
                  <a:spcPct val="90000"/>
                </a:lnSpc>
                <a:spcBef>
                  <a:spcPts val="0"/>
                </a:spcBef>
                <a:spcAft>
                  <a:spcPts val="450"/>
                </a:spcAft>
                <a:buClr>
                  <a:schemeClr val="accent4"/>
                </a:buClr>
                <a:buFont typeface="Arial" pitchFamily="34" charset="0"/>
                <a:buChar char="•"/>
                <a:defRPr sz="1200" kern="1200">
                  <a:solidFill>
                    <a:schemeClr val="tx1"/>
                  </a:solidFill>
                  <a:latin typeface="+mn-lt"/>
                  <a:ea typeface="+mn-ea"/>
                  <a:cs typeface="Arial" pitchFamily="34" charset="0"/>
                </a:defRPr>
              </a:lvl3pPr>
              <a:lvl4pPr marL="685800" indent="-170260" algn="l" defTabSz="685800" rtl="0" eaLnBrk="1" latinLnBrk="0" hangingPunct="1">
                <a:lnSpc>
                  <a:spcPct val="90000"/>
                </a:lnSpc>
                <a:spcBef>
                  <a:spcPts val="0"/>
                </a:spcBef>
                <a:spcAft>
                  <a:spcPts val="450"/>
                </a:spcAft>
                <a:buClr>
                  <a:schemeClr val="accent4"/>
                </a:buClr>
                <a:buSzPct val="85000"/>
                <a:buFont typeface="Arial" pitchFamily="34" charset="0"/>
                <a:buChar char="–"/>
                <a:defRPr sz="1050" kern="1200">
                  <a:solidFill>
                    <a:schemeClr val="tx1"/>
                  </a:solidFill>
                  <a:latin typeface="+mn-lt"/>
                  <a:ea typeface="+mn-ea"/>
                  <a:cs typeface="Arial" pitchFamily="34" charset="0"/>
                </a:defRPr>
              </a:lvl4pPr>
              <a:lvl5pPr marL="813197" indent="-127397" algn="l" defTabSz="685800" rtl="0" eaLnBrk="1" latinLnBrk="0" hangingPunct="1">
                <a:lnSpc>
                  <a:spcPct val="90000"/>
                </a:lnSpc>
                <a:spcBef>
                  <a:spcPts val="0"/>
                </a:spcBef>
                <a:spcAft>
                  <a:spcPts val="450"/>
                </a:spcAft>
                <a:buClr>
                  <a:schemeClr val="accent4"/>
                </a:buClr>
                <a:buFont typeface="Arial" pitchFamily="34" charset="0"/>
                <a:buChar char="•"/>
                <a:defRPr sz="900" kern="1200">
                  <a:solidFill>
                    <a:schemeClr val="tx1"/>
                  </a:solidFill>
                  <a:latin typeface="+mn-lt"/>
                  <a:ea typeface="+mn-ea"/>
                  <a:cs typeface="Arial" pitchFamily="34" charset="0"/>
                </a:defRPr>
              </a:lvl5pPr>
              <a:lvl6pPr marL="942975" indent="-129779" algn="l" defTabSz="685800" rtl="0" eaLnBrk="1" latinLnBrk="0" hangingPunct="1">
                <a:lnSpc>
                  <a:spcPct val="90000"/>
                </a:lnSpc>
                <a:spcBef>
                  <a:spcPts val="0"/>
                </a:spcBef>
                <a:spcAft>
                  <a:spcPts val="450"/>
                </a:spcAft>
                <a:buClr>
                  <a:schemeClr val="tx1"/>
                </a:buClr>
                <a:buSzPct val="85000"/>
                <a:buFont typeface="Arial" pitchFamily="34" charset="0"/>
                <a:buChar char="–"/>
                <a:defRPr sz="9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228850" indent="-171450" algn="l" defTabSz="685800" rtl="0" eaLnBrk="1" latinLnBrk="0" hangingPunct="1">
                <a:spcBef>
                  <a:spcPct val="20000"/>
                </a:spcBef>
                <a:buFont typeface="Arial" pitchFamily="34" charset="0"/>
                <a:buChar char="•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571750" indent="-171450" algn="l" defTabSz="685800" rtl="0" eaLnBrk="1" latinLnBrk="0" hangingPunct="1">
                <a:spcBef>
                  <a:spcPct val="20000"/>
                </a:spcBef>
                <a:buFont typeface="Arial" pitchFamily="34" charset="0"/>
                <a:buChar char="•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914650" indent="-171450" algn="l" defTabSz="685800" rtl="0" eaLnBrk="1" latinLnBrk="0" hangingPunct="1">
                <a:spcBef>
                  <a:spcPct val="20000"/>
                </a:spcBef>
                <a:buFont typeface="Arial" pitchFamily="34" charset="0"/>
                <a:buChar char="•"/>
                <a:defRPr sz="15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1050" kern="0" dirty="0"/>
                <a:t>10nM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2D3DCA5-ADF0-4BE1-A742-080CC235B969}"/>
                </a:ext>
              </a:extLst>
            </p:cNvPr>
            <p:cNvCxnSpPr/>
            <p:nvPr/>
          </p:nvCxnSpPr>
          <p:spPr>
            <a:xfrm>
              <a:off x="228600" y="4969327"/>
              <a:ext cx="6181344" cy="0"/>
            </a:xfrm>
            <a:prstGeom prst="line">
              <a:avLst/>
            </a:prstGeom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349937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8" descr="A picture containing chart&#10;&#10;Description automatically generated">
            <a:extLst>
              <a:ext uri="{FF2B5EF4-FFF2-40B4-BE49-F238E27FC236}">
                <a16:creationId xmlns:a16="http://schemas.microsoft.com/office/drawing/2014/main" id="{CE627CD5-A048-460A-AE60-12BD07D249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990" y="1280732"/>
            <a:ext cx="10972823" cy="487680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093272F-7115-4F17-9B81-3AE7FA53FA65}"/>
              </a:ext>
            </a:extLst>
          </p:cNvPr>
          <p:cNvCxnSpPr>
            <a:cxnSpLocks/>
          </p:cNvCxnSpPr>
          <p:nvPr/>
        </p:nvCxnSpPr>
        <p:spPr>
          <a:xfrm flipV="1">
            <a:off x="3023024" y="2023114"/>
            <a:ext cx="0" cy="9867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155F3223-3A9A-42C6-B70B-AEFBE699D3C1}"/>
              </a:ext>
            </a:extLst>
          </p:cNvPr>
          <p:cNvCxnSpPr/>
          <p:nvPr/>
        </p:nvCxnSpPr>
        <p:spPr>
          <a:xfrm>
            <a:off x="1604022" y="2027192"/>
            <a:ext cx="14149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079BD39-1160-47C5-801E-32F77AD169D8}"/>
              </a:ext>
            </a:extLst>
          </p:cNvPr>
          <p:cNvCxnSpPr>
            <a:cxnSpLocks/>
          </p:cNvCxnSpPr>
          <p:nvPr/>
        </p:nvCxnSpPr>
        <p:spPr>
          <a:xfrm flipV="1">
            <a:off x="5771321" y="2039427"/>
            <a:ext cx="0" cy="68503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C30EFE9-7EB3-4F83-8BBF-68D40665CD7C}"/>
              </a:ext>
            </a:extLst>
          </p:cNvPr>
          <p:cNvCxnSpPr>
            <a:cxnSpLocks/>
          </p:cNvCxnSpPr>
          <p:nvPr/>
        </p:nvCxnSpPr>
        <p:spPr>
          <a:xfrm flipV="1">
            <a:off x="7190324" y="2031270"/>
            <a:ext cx="0" cy="11539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F509CD2-A7FD-4449-9FBE-0AC04A2757DE}"/>
              </a:ext>
            </a:extLst>
          </p:cNvPr>
          <p:cNvCxnSpPr/>
          <p:nvPr/>
        </p:nvCxnSpPr>
        <p:spPr>
          <a:xfrm>
            <a:off x="5771322" y="2035348"/>
            <a:ext cx="14149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9EC811A1-6464-4A98-9F13-F81FAA9B6A8C}"/>
              </a:ext>
            </a:extLst>
          </p:cNvPr>
          <p:cNvCxnSpPr>
            <a:cxnSpLocks/>
          </p:cNvCxnSpPr>
          <p:nvPr/>
        </p:nvCxnSpPr>
        <p:spPr>
          <a:xfrm flipV="1">
            <a:off x="7854971" y="2035350"/>
            <a:ext cx="0" cy="6891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9A2BD037-DE2A-4BAF-B01A-8067731FAFD1}"/>
              </a:ext>
            </a:extLst>
          </p:cNvPr>
          <p:cNvCxnSpPr>
            <a:cxnSpLocks/>
          </p:cNvCxnSpPr>
          <p:nvPr/>
        </p:nvCxnSpPr>
        <p:spPr>
          <a:xfrm flipV="1">
            <a:off x="9273973" y="2027192"/>
            <a:ext cx="0" cy="187977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A598666-1336-46B2-B84F-A0D860090145}"/>
              </a:ext>
            </a:extLst>
          </p:cNvPr>
          <p:cNvCxnSpPr/>
          <p:nvPr/>
        </p:nvCxnSpPr>
        <p:spPr>
          <a:xfrm>
            <a:off x="7854971" y="2031271"/>
            <a:ext cx="14149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CAA00241-CD0E-4CB9-96B4-731F052ADBF2}"/>
              </a:ext>
            </a:extLst>
          </p:cNvPr>
          <p:cNvCxnSpPr>
            <a:cxnSpLocks/>
          </p:cNvCxnSpPr>
          <p:nvPr/>
        </p:nvCxnSpPr>
        <p:spPr>
          <a:xfrm flipV="1">
            <a:off x="5114829" y="2019039"/>
            <a:ext cx="0" cy="156987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FC9E454-A5E4-4EBC-8F23-7D8029C29BAD}"/>
              </a:ext>
            </a:extLst>
          </p:cNvPr>
          <p:cNvCxnSpPr/>
          <p:nvPr/>
        </p:nvCxnSpPr>
        <p:spPr>
          <a:xfrm>
            <a:off x="3695827" y="2023116"/>
            <a:ext cx="14149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82573F8-21AC-4ECB-92C6-80569620D514}"/>
              </a:ext>
            </a:extLst>
          </p:cNvPr>
          <p:cNvSpPr txBox="1"/>
          <p:nvPr/>
        </p:nvSpPr>
        <p:spPr>
          <a:xfrm>
            <a:off x="2019260" y="2035349"/>
            <a:ext cx="48782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600" dirty="0"/>
              <a:t>3-fold</a:t>
            </a:r>
          </a:p>
        </p:txBody>
      </p:sp>
      <p:sp>
        <p:nvSpPr>
          <p:cNvPr id="14" name="Arrow: Up 13">
            <a:extLst>
              <a:ext uri="{FF2B5EF4-FFF2-40B4-BE49-F238E27FC236}">
                <a16:creationId xmlns:a16="http://schemas.microsoft.com/office/drawing/2014/main" id="{7A5F8C3E-191E-4127-82D5-6B74DEF02D78}"/>
              </a:ext>
            </a:extLst>
          </p:cNvPr>
          <p:cNvSpPr/>
          <p:nvPr/>
        </p:nvSpPr>
        <p:spPr>
          <a:xfrm flipV="1">
            <a:off x="2581969" y="2082236"/>
            <a:ext cx="89708" cy="165144"/>
          </a:xfrm>
          <a:prstGeom prst="upArrow">
            <a:avLst/>
          </a:prstGeom>
          <a:solidFill>
            <a:srgbClr val="C77CFF"/>
          </a:solidFill>
          <a:ln w="127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6000" tIns="96000" rIns="96000" bIns="96000" rtlCol="0" anchor="ctr"/>
          <a:lstStyle/>
          <a:p>
            <a:pPr algn="ctr"/>
            <a:endParaRPr lang="en-US" sz="1867" dirty="0" err="1">
              <a:solidFill>
                <a:schemeClr val="tx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31A4DA9-1F89-4A3A-9EE4-B93A269A6214}"/>
              </a:ext>
            </a:extLst>
          </p:cNvPr>
          <p:cNvSpPr txBox="1"/>
          <p:nvPr/>
        </p:nvSpPr>
        <p:spPr>
          <a:xfrm>
            <a:off x="4127369" y="2038746"/>
            <a:ext cx="48782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600" dirty="0"/>
              <a:t>5-fold</a:t>
            </a:r>
          </a:p>
        </p:txBody>
      </p:sp>
      <p:sp>
        <p:nvSpPr>
          <p:cNvPr id="16" name="Arrow: Up 15">
            <a:extLst>
              <a:ext uri="{FF2B5EF4-FFF2-40B4-BE49-F238E27FC236}">
                <a16:creationId xmlns:a16="http://schemas.microsoft.com/office/drawing/2014/main" id="{744F13DE-4425-4393-8318-BC489BE8B090}"/>
              </a:ext>
            </a:extLst>
          </p:cNvPr>
          <p:cNvSpPr/>
          <p:nvPr/>
        </p:nvSpPr>
        <p:spPr>
          <a:xfrm flipV="1">
            <a:off x="4690083" y="2085634"/>
            <a:ext cx="89708" cy="165144"/>
          </a:xfrm>
          <a:prstGeom prst="upArrow">
            <a:avLst/>
          </a:prstGeom>
          <a:solidFill>
            <a:srgbClr val="C77CFF"/>
          </a:solidFill>
          <a:ln w="127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6000" tIns="96000" rIns="96000" bIns="96000" rtlCol="0" anchor="ctr"/>
          <a:lstStyle/>
          <a:p>
            <a:pPr algn="ctr"/>
            <a:endParaRPr lang="en-US" sz="1867" dirty="0" err="1">
              <a:solidFill>
                <a:schemeClr val="tx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428D39-A01C-4215-8E05-A3DBFAB37B4C}"/>
              </a:ext>
            </a:extLst>
          </p:cNvPr>
          <p:cNvSpPr txBox="1"/>
          <p:nvPr/>
        </p:nvSpPr>
        <p:spPr>
          <a:xfrm>
            <a:off x="6092098" y="2042613"/>
            <a:ext cx="643318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600" dirty="0"/>
              <a:t>1.5-fold</a:t>
            </a:r>
          </a:p>
        </p:txBody>
      </p:sp>
      <p:sp>
        <p:nvSpPr>
          <p:cNvPr id="18" name="Arrow: Up 17">
            <a:extLst>
              <a:ext uri="{FF2B5EF4-FFF2-40B4-BE49-F238E27FC236}">
                <a16:creationId xmlns:a16="http://schemas.microsoft.com/office/drawing/2014/main" id="{2118244B-EF31-4BA3-8773-7D9B728B77E1}"/>
              </a:ext>
            </a:extLst>
          </p:cNvPr>
          <p:cNvSpPr/>
          <p:nvPr/>
        </p:nvSpPr>
        <p:spPr>
          <a:xfrm flipV="1">
            <a:off x="6793437" y="2089500"/>
            <a:ext cx="89708" cy="165144"/>
          </a:xfrm>
          <a:prstGeom prst="upArrow">
            <a:avLst/>
          </a:prstGeom>
          <a:solidFill>
            <a:srgbClr val="C77CFF"/>
          </a:solidFill>
          <a:ln w="127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6000" tIns="96000" rIns="96000" bIns="96000" rtlCol="0" anchor="ctr"/>
          <a:lstStyle/>
          <a:p>
            <a:pPr algn="ctr"/>
            <a:endParaRPr lang="en-US" sz="1867" dirty="0" err="1">
              <a:solidFill>
                <a:schemeClr val="tx1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6627D14-84E7-4443-BCFF-7810E7E46738}"/>
              </a:ext>
            </a:extLst>
          </p:cNvPr>
          <p:cNvSpPr txBox="1"/>
          <p:nvPr/>
        </p:nvSpPr>
        <p:spPr>
          <a:xfrm>
            <a:off x="8228752" y="2027194"/>
            <a:ext cx="48782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600" dirty="0"/>
              <a:t>5-fold</a:t>
            </a:r>
          </a:p>
        </p:txBody>
      </p:sp>
      <p:sp>
        <p:nvSpPr>
          <p:cNvPr id="20" name="Arrow: Up 19">
            <a:extLst>
              <a:ext uri="{FF2B5EF4-FFF2-40B4-BE49-F238E27FC236}">
                <a16:creationId xmlns:a16="http://schemas.microsoft.com/office/drawing/2014/main" id="{DA548D14-4E01-4DD3-92CA-7CC69EFE22AB}"/>
              </a:ext>
            </a:extLst>
          </p:cNvPr>
          <p:cNvSpPr/>
          <p:nvPr/>
        </p:nvSpPr>
        <p:spPr>
          <a:xfrm flipV="1">
            <a:off x="8836313" y="2074082"/>
            <a:ext cx="89708" cy="165144"/>
          </a:xfrm>
          <a:prstGeom prst="upArrow">
            <a:avLst/>
          </a:prstGeom>
          <a:solidFill>
            <a:srgbClr val="C77CFF"/>
          </a:solidFill>
          <a:ln w="127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6000" tIns="96000" rIns="96000" bIns="96000" rtlCol="0" anchor="ctr"/>
          <a:lstStyle/>
          <a:p>
            <a:pPr algn="ctr"/>
            <a:endParaRPr lang="en-US" sz="1867" dirty="0" err="1">
              <a:solidFill>
                <a:schemeClr val="tx1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D68BD55-EB9D-43F6-967A-E3CAACD29C57}"/>
              </a:ext>
            </a:extLst>
          </p:cNvPr>
          <p:cNvSpPr txBox="1"/>
          <p:nvPr/>
        </p:nvSpPr>
        <p:spPr>
          <a:xfrm>
            <a:off x="10229615" y="3213541"/>
            <a:ext cx="1179810" cy="2051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de-AT" sz="1333" dirty="0"/>
              <a:t>10 nM BI 894999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95D573D-BDEC-4A92-AAF4-E7EC5A659F07}"/>
              </a:ext>
            </a:extLst>
          </p:cNvPr>
          <p:cNvSpPr txBox="1"/>
          <p:nvPr/>
        </p:nvSpPr>
        <p:spPr>
          <a:xfrm>
            <a:off x="10229615" y="3499689"/>
            <a:ext cx="1179810" cy="2051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de-AT" sz="1333" dirty="0"/>
              <a:t>300 nM CCS147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01FED13-46B7-40A8-BF8D-BD568C1CCB03}"/>
              </a:ext>
            </a:extLst>
          </p:cNvPr>
          <p:cNvSpPr txBox="1"/>
          <p:nvPr/>
        </p:nvSpPr>
        <p:spPr>
          <a:xfrm>
            <a:off x="10229615" y="3785837"/>
            <a:ext cx="1396328" cy="2051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de-AT" sz="1333" dirty="0" err="1"/>
              <a:t>Combination</a:t>
            </a:r>
            <a:r>
              <a:rPr lang="de-AT" sz="1333" dirty="0"/>
              <a:t>         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73F73C9-4E38-4856-9474-115F896FA454}"/>
              </a:ext>
            </a:extLst>
          </p:cNvPr>
          <p:cNvSpPr txBox="1"/>
          <p:nvPr/>
        </p:nvSpPr>
        <p:spPr>
          <a:xfrm>
            <a:off x="517167" y="387109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7</a:t>
            </a:r>
          </a:p>
        </p:txBody>
      </p:sp>
    </p:spTree>
    <p:extLst>
      <p:ext uri="{BB962C8B-B14F-4D97-AF65-F5344CB8AC3E}">
        <p14:creationId xmlns:p14="http://schemas.microsoft.com/office/powerpoint/2010/main" val="14781810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5">
            <a:extLst>
              <a:ext uri="{FF2B5EF4-FFF2-40B4-BE49-F238E27FC236}">
                <a16:creationId xmlns:a16="http://schemas.microsoft.com/office/drawing/2014/main" id="{9B8901E6-A724-41FB-9014-B2DB2B9378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6157" y="1199204"/>
            <a:ext cx="5246628" cy="393497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D7FF2B7-99CD-4073-A245-1F61AB305A4C}"/>
              </a:ext>
            </a:extLst>
          </p:cNvPr>
          <p:cNvSpPr txBox="1"/>
          <p:nvPr/>
        </p:nvSpPr>
        <p:spPr>
          <a:xfrm>
            <a:off x="368004" y="290364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8</a:t>
            </a:r>
          </a:p>
        </p:txBody>
      </p:sp>
    </p:spTree>
    <p:extLst>
      <p:ext uri="{BB962C8B-B14F-4D97-AF65-F5344CB8AC3E}">
        <p14:creationId xmlns:p14="http://schemas.microsoft.com/office/powerpoint/2010/main" val="421249327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Slide Number Placeholder 3">
            <a:extLst>
              <a:ext uri="{FF2B5EF4-FFF2-40B4-BE49-F238E27FC236}">
                <a16:creationId xmlns:a16="http://schemas.microsoft.com/office/drawing/2014/main" id="{619E74FB-5D90-4062-9D80-31F4EAD3EC0A}"/>
              </a:ext>
            </a:extLst>
          </p:cNvPr>
          <p:cNvSpPr txBox="1">
            <a:spLocks/>
          </p:cNvSpPr>
          <p:nvPr/>
        </p:nvSpPr>
        <p:spPr>
          <a:xfrm>
            <a:off x="8628950" y="4688284"/>
            <a:ext cx="147476" cy="153888"/>
          </a:xfrm>
          <a:prstGeom prst="rect">
            <a:avLst/>
          </a:prstGeom>
        </p:spPr>
        <p:txBody>
          <a:bodyPr vert="horz" wrap="none" lIns="0" tIns="0" rIns="0" bIns="0" rtlCol="0" anchor="ctr">
            <a:spAutoFit/>
          </a:bodyPr>
          <a:lstStyle>
            <a:defPPr>
              <a:defRPr lang="de-DE"/>
            </a:defPPr>
            <a:lvl1pPr marL="0" algn="r" defTabSz="914400" rtl="0" eaLnBrk="1" latinLnBrk="0" hangingPunct="1">
              <a:defRPr sz="1333" kern="1200">
                <a:solidFill>
                  <a:schemeClr val="bg1">
                    <a:lumMod val="50000"/>
                  </a:schemeClr>
                </a:solidFill>
                <a:latin typeface="BISansCond" panose="02000006050000020004" pitchFamily="2" charset="0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r" defTabSz="91437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43B55C4-4F5A-416B-997D-6CE47EB0A945}" type="slidenum">
              <a:rPr kumimoji="0" lang="en-GB" sz="1000" b="0" i="0" u="none" strike="noStrike" kern="1200" cap="none" spc="0" normalizeH="0" baseline="0" noProof="0" smtClean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BISansCond" panose="02000006050000020004" pitchFamily="2" charset="0"/>
                <a:ea typeface="+mn-ea"/>
                <a:cs typeface="+mn-cs"/>
              </a:rPr>
              <a:pPr marL="0" marR="0" lvl="0" indent="0" algn="r" defTabSz="914377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srgbClr val="FFFFFF">
                  <a:lumMod val="50000"/>
                </a:srgbClr>
              </a:solidFill>
              <a:effectLst/>
              <a:uLnTx/>
              <a:uFillTx/>
              <a:latin typeface="BISansCond" panose="02000006050000020004" pitchFamily="2" charset="0"/>
              <a:ea typeface="+mn-ea"/>
              <a:cs typeface="+mn-cs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FC90F6D-EAC7-40C1-9991-853C9DB84F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8551">
            <a:off x="5776246" y="1694265"/>
            <a:ext cx="539381" cy="39802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56E9AE4-1AF1-40CE-B7EB-4C87F2386D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764226">
            <a:off x="5653178" y="1373393"/>
            <a:ext cx="539381" cy="39802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F6F033F-4686-4E5C-9FD8-73235B3CC5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869700">
            <a:off x="6004974" y="1489709"/>
            <a:ext cx="539381" cy="39802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CE0ADFC-1F89-415D-B612-8D71AFE8E2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5479" y="1489709"/>
            <a:ext cx="539381" cy="39802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37BF8EC-CFD3-48E5-947C-2DDCAF47B3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5005" y="1607237"/>
            <a:ext cx="1244600" cy="2351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3E498F6-AC8A-47D4-9224-C0F812CE1206}"/>
              </a:ext>
            </a:extLst>
          </p:cNvPr>
          <p:cNvSpPr txBox="1"/>
          <p:nvPr/>
        </p:nvSpPr>
        <p:spPr>
          <a:xfrm>
            <a:off x="3788596" y="2101403"/>
            <a:ext cx="2644587" cy="49244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377">
              <a:defRPr/>
            </a:pPr>
            <a:r>
              <a:rPr lang="de-AT" sz="1600" dirty="0">
                <a:solidFill>
                  <a:srgbClr val="000000"/>
                </a:solidFill>
                <a:latin typeface="BISansOpti"/>
              </a:rPr>
              <a:t>3</a:t>
            </a:r>
            <a:r>
              <a:rPr lang="de-AT" sz="1600" dirty="0"/>
              <a:t>-</a:t>
            </a:r>
            <a:r>
              <a:rPr lang="de-AT" sz="1600" dirty="0">
                <a:latin typeface="BISansOpti"/>
              </a:rPr>
              <a:t>f</a:t>
            </a:r>
            <a:r>
              <a:rPr lang="de-AT" sz="1600" dirty="0">
                <a:solidFill>
                  <a:srgbClr val="000000"/>
                </a:solidFill>
                <a:latin typeface="BISansOpti"/>
              </a:rPr>
              <a:t>old increase in tumor volume within a week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7CB13CD-66C9-4B18-8825-83A30B05D37C}"/>
              </a:ext>
            </a:extLst>
          </p:cNvPr>
          <p:cNvSpPr txBox="1"/>
          <p:nvPr/>
        </p:nvSpPr>
        <p:spPr>
          <a:xfrm>
            <a:off x="1435288" y="3469709"/>
            <a:ext cx="1908856" cy="215444"/>
          </a:xfrm>
          <a:prstGeom prst="rect">
            <a:avLst/>
          </a:prstGeom>
          <a:solidFill>
            <a:srgbClr val="6699CC">
              <a:lumMod val="20000"/>
              <a:lumOff val="80000"/>
            </a:srgbClr>
          </a:solidFill>
          <a:ln>
            <a:solidFill>
              <a:srgbClr val="003366"/>
            </a:solidFill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defTabSz="914377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AT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ISansOpti"/>
              </a:rPr>
              <a:t> </a:t>
            </a:r>
            <a:r>
              <a:rPr kumimoji="0" lang="de-AT" sz="14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ISansOpti"/>
              </a:rPr>
              <a:t>Readout</a:t>
            </a:r>
            <a:r>
              <a:rPr kumimoji="0" lang="de-AT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ISansOpti"/>
              </a:rPr>
              <a:t> after </a:t>
            </a:r>
            <a:r>
              <a:rPr kumimoji="0" lang="de-AT" sz="14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ISansOpti"/>
              </a:rPr>
              <a:t>one</a:t>
            </a:r>
            <a:r>
              <a:rPr kumimoji="0" lang="de-AT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ISansOpti"/>
              </a:rPr>
              <a:t> week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88FA873-3407-4D03-848E-71827D5886DB}"/>
              </a:ext>
            </a:extLst>
          </p:cNvPr>
          <p:cNvSpPr txBox="1"/>
          <p:nvPr/>
        </p:nvSpPr>
        <p:spPr>
          <a:xfrm>
            <a:off x="4275005" y="1124101"/>
            <a:ext cx="1472767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377">
              <a:defRPr/>
            </a:pPr>
            <a:r>
              <a:rPr lang="de-AT" sz="1600" dirty="0">
                <a:solidFill>
                  <a:srgbClr val="000000"/>
                </a:solidFill>
                <a:latin typeface="BISansOpti"/>
              </a:rPr>
              <a:t>Ty-82 kinetic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4ABE387-ED2F-4A9D-BC54-A6A788AECB2B}"/>
              </a:ext>
            </a:extLst>
          </p:cNvPr>
          <p:cNvSpPr txBox="1"/>
          <p:nvPr/>
        </p:nvSpPr>
        <p:spPr>
          <a:xfrm>
            <a:off x="4769708" y="5613551"/>
            <a:ext cx="6585371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377">
              <a:defRPr/>
            </a:pPr>
            <a:r>
              <a:rPr lang="de-AT" sz="1400" dirty="0">
                <a:solidFill>
                  <a:srgbClr val="000000"/>
                </a:solidFill>
                <a:latin typeface="BISansOpti"/>
              </a:rPr>
              <a:t>*</a:t>
            </a:r>
            <a:r>
              <a:rPr lang="de-AT" sz="1400" baseline="30000" dirty="0">
                <a:solidFill>
                  <a:srgbClr val="000000"/>
                </a:solidFill>
                <a:latin typeface="BISansOpti"/>
              </a:rPr>
              <a:t>#</a:t>
            </a:r>
            <a:r>
              <a:rPr lang="de-AT" sz="1400" dirty="0">
                <a:solidFill>
                  <a:srgbClr val="000000"/>
                </a:solidFill>
                <a:latin typeface="BISansOpti"/>
              </a:rPr>
              <a:t>Based on data from previous </a:t>
            </a:r>
            <a:r>
              <a:rPr lang="de-AT" sz="1400" i="1" dirty="0">
                <a:solidFill>
                  <a:srgbClr val="000000"/>
                </a:solidFill>
                <a:latin typeface="BISansOpti"/>
              </a:rPr>
              <a:t>in vivo </a:t>
            </a:r>
            <a:r>
              <a:rPr lang="de-AT" sz="1400" dirty="0">
                <a:solidFill>
                  <a:srgbClr val="000000"/>
                </a:solidFill>
                <a:latin typeface="BISansOpti"/>
              </a:rPr>
              <a:t>experiments in other model (</a:t>
            </a:r>
            <a:r>
              <a:rPr lang="en-US" sz="1400" dirty="0"/>
              <a:t>NMRI-nude mice)</a:t>
            </a:r>
            <a:r>
              <a:rPr lang="de-AT" sz="1400" dirty="0">
                <a:solidFill>
                  <a:srgbClr val="000000"/>
                </a:solidFill>
                <a:latin typeface="BISansOpti"/>
              </a:rPr>
              <a:t> </a:t>
            </a:r>
          </a:p>
        </p:txBody>
      </p:sp>
      <p:graphicFrame>
        <p:nvGraphicFramePr>
          <p:cNvPr id="28" name="Table 27">
            <a:extLst>
              <a:ext uri="{FF2B5EF4-FFF2-40B4-BE49-F238E27FC236}">
                <a16:creationId xmlns:a16="http://schemas.microsoft.com/office/drawing/2014/main" id="{B190E9FD-88BF-499B-9914-CCBA9679E75F}"/>
              </a:ext>
            </a:extLst>
          </p:cNvPr>
          <p:cNvGraphicFramePr>
            <a:graphicFrameLocks noGrp="1"/>
          </p:cNvGraphicFramePr>
          <p:nvPr/>
        </p:nvGraphicFramePr>
        <p:xfrm>
          <a:off x="667019" y="2966613"/>
          <a:ext cx="10598885" cy="2566905"/>
        </p:xfrm>
        <a:graphic>
          <a:graphicData uri="http://schemas.openxmlformats.org/drawingml/2006/table">
            <a:tbl>
              <a:tblPr firstRow="1" bandRow="1"/>
              <a:tblGrid>
                <a:gridCol w="1764000">
                  <a:extLst>
                    <a:ext uri="{9D8B030D-6E8A-4147-A177-3AD203B41FA5}">
                      <a16:colId xmlns:a16="http://schemas.microsoft.com/office/drawing/2014/main" val="3457040095"/>
                    </a:ext>
                  </a:extLst>
                </a:gridCol>
                <a:gridCol w="986885">
                  <a:extLst>
                    <a:ext uri="{9D8B030D-6E8A-4147-A177-3AD203B41FA5}">
                      <a16:colId xmlns:a16="http://schemas.microsoft.com/office/drawing/2014/main" val="1012679496"/>
                    </a:ext>
                  </a:extLst>
                </a:gridCol>
                <a:gridCol w="3384000">
                  <a:extLst>
                    <a:ext uri="{9D8B030D-6E8A-4147-A177-3AD203B41FA5}">
                      <a16:colId xmlns:a16="http://schemas.microsoft.com/office/drawing/2014/main" val="784199889"/>
                    </a:ext>
                  </a:extLst>
                </a:gridCol>
                <a:gridCol w="1800000">
                  <a:extLst>
                    <a:ext uri="{9D8B030D-6E8A-4147-A177-3AD203B41FA5}">
                      <a16:colId xmlns:a16="http://schemas.microsoft.com/office/drawing/2014/main" val="529777505"/>
                    </a:ext>
                  </a:extLst>
                </a:gridCol>
                <a:gridCol w="1332000">
                  <a:extLst>
                    <a:ext uri="{9D8B030D-6E8A-4147-A177-3AD203B41FA5}">
                      <a16:colId xmlns:a16="http://schemas.microsoft.com/office/drawing/2014/main" val="1147186928"/>
                    </a:ext>
                  </a:extLst>
                </a:gridCol>
                <a:gridCol w="1332000">
                  <a:extLst>
                    <a:ext uri="{9D8B030D-6E8A-4147-A177-3AD203B41FA5}">
                      <a16:colId xmlns:a16="http://schemas.microsoft.com/office/drawing/2014/main" val="4034828490"/>
                    </a:ext>
                  </a:extLst>
                </a:gridCol>
              </a:tblGrid>
              <a:tr h="335280"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bg1"/>
                          </a:solidFill>
                        </a:rPr>
                        <a:t>Dosing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800" b="1" kern="1200" dirty="0" err="1">
                          <a:solidFill>
                            <a:schemeClr val="bg1"/>
                          </a:solidFill>
                          <a:effectLst/>
                          <a:latin typeface="BISans"/>
                          <a:ea typeface="+mn-ea"/>
                          <a:cs typeface="+mn-cs"/>
                        </a:rPr>
                        <a:t>C</a:t>
                      </a:r>
                      <a:r>
                        <a:rPr lang="de-AT" sz="1800" b="1" kern="1200" baseline="-25000" dirty="0" err="1">
                          <a:solidFill>
                            <a:schemeClr val="bg1"/>
                          </a:solidFill>
                          <a:effectLst/>
                          <a:latin typeface="BISans"/>
                          <a:ea typeface="+mn-ea"/>
                          <a:cs typeface="+mn-cs"/>
                        </a:rPr>
                        <a:t>max</a:t>
                      </a:r>
                      <a:endParaRPr lang="de-AT" sz="16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/>
                        <a:t>Pathway Modulation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tc gridSpan="3"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BISans"/>
                        </a:defRPr>
                      </a:lvl9pPr>
                    </a:lstStyle>
                    <a:p>
                      <a:pPr algn="ctr"/>
                      <a:r>
                        <a:rPr lang="de-AT" sz="1600" dirty="0" err="1"/>
                        <a:t>Readout</a:t>
                      </a:r>
                      <a:r>
                        <a:rPr lang="de-AT" sz="1600" dirty="0"/>
                        <a:t> after </a:t>
                      </a:r>
                      <a:r>
                        <a:rPr lang="de-AT" sz="1600" dirty="0" err="1"/>
                        <a:t>one</a:t>
                      </a:r>
                      <a:r>
                        <a:rPr lang="de-AT" sz="1600" dirty="0"/>
                        <a:t> week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529715"/>
                  </a:ext>
                </a:extLst>
              </a:tr>
              <a:tr h="335280"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b="1" dirty="0" err="1">
                          <a:solidFill>
                            <a:schemeClr val="bg1"/>
                          </a:solidFill>
                        </a:rPr>
                        <a:t>Regressions</a:t>
                      </a:r>
                      <a:r>
                        <a:rPr lang="de-AT" sz="1600" b="1" dirty="0">
                          <a:solidFill>
                            <a:schemeClr val="bg1"/>
                          </a:solidFill>
                        </a:rPr>
                        <a:t>  n (%)</a:t>
                      </a:r>
                    </a:p>
                  </a:txBody>
                  <a:tcPr>
                    <a:lnL w="381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b="1" dirty="0">
                          <a:solidFill>
                            <a:schemeClr val="bg1"/>
                          </a:solidFill>
                        </a:rPr>
                        <a:t>SD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b="1" dirty="0">
                          <a:solidFill>
                            <a:schemeClr val="bg1"/>
                          </a:solidFill>
                        </a:rPr>
                        <a:t>PD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5381721"/>
                  </a:ext>
                </a:extLst>
              </a:tr>
              <a:tr h="57912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2  mg/kg BID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1600" dirty="0"/>
                        <a:t>10 nM*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HEXIM1</a:t>
                      </a:r>
                      <a:r>
                        <a:rPr lang="de-AT" sz="1600" baseline="0" dirty="0">
                          <a:solidFill>
                            <a:schemeClr val="tx1"/>
                          </a:solidFill>
                        </a:rPr>
                        <a:t> modulation</a:t>
                      </a:r>
                      <a:r>
                        <a:rPr lang="de-AT" sz="1600" baseline="30000" dirty="0">
                          <a:solidFill>
                            <a:schemeClr val="tx1"/>
                          </a:solidFill>
                        </a:rPr>
                        <a:t>#</a:t>
                      </a:r>
                      <a:r>
                        <a:rPr lang="de-AT" sz="1600" baseline="0" dirty="0">
                          <a:solidFill>
                            <a:schemeClr val="tx1"/>
                          </a:solidFill>
                        </a:rPr>
                        <a:t> @ 2 mg /kg qd in tumor: 2.5 fold / in blood: 2-fold</a:t>
                      </a:r>
                      <a:endParaRPr lang="de-AT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2 (25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2 (25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4 (50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181025"/>
                  </a:ext>
                </a:extLst>
              </a:tr>
              <a:tr h="73810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b="0" dirty="0">
                          <a:solidFill>
                            <a:schemeClr val="tx1"/>
                          </a:solidFill>
                        </a:rPr>
                        <a:t>4 mg/kg qd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30 nM*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HEXIM1</a:t>
                      </a:r>
                      <a:r>
                        <a:rPr lang="de-AT" sz="1600" baseline="0" dirty="0">
                          <a:solidFill>
                            <a:schemeClr val="tx1"/>
                          </a:solidFill>
                        </a:rPr>
                        <a:t> modulation</a:t>
                      </a:r>
                      <a:r>
                        <a:rPr lang="de-AT" sz="1600" baseline="30000" dirty="0">
                          <a:solidFill>
                            <a:schemeClr val="tx1"/>
                          </a:solidFill>
                        </a:rPr>
                        <a:t>#</a:t>
                      </a:r>
                    </a:p>
                    <a:p>
                      <a:r>
                        <a:rPr lang="de-AT" sz="1600" baseline="0" dirty="0">
                          <a:solidFill>
                            <a:schemeClr val="tx1"/>
                          </a:solidFill>
                        </a:rPr>
                        <a:t>in tumor: 4 fold / in blood: 3-fold</a:t>
                      </a:r>
                      <a:endParaRPr lang="de-AT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4 (50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1 (12.5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3 (37.5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4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3775273"/>
                  </a:ext>
                </a:extLst>
              </a:tr>
              <a:tr h="57912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/>
                        <a:t>12 </a:t>
                      </a:r>
                      <a:r>
                        <a:rPr lang="de-AT" sz="1600" dirty="0">
                          <a:sym typeface="Wingdings" panose="05000000000000000000" pitchFamily="2" charset="2"/>
                        </a:rPr>
                        <a:t> 8</a:t>
                      </a:r>
                      <a:r>
                        <a:rPr lang="de-AT" sz="1600" baseline="0" dirty="0"/>
                        <a:t> mg/kg qd</a:t>
                      </a:r>
                      <a:endParaRPr lang="de-AT" sz="1600" dirty="0"/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 err="1"/>
                        <a:t>n.d</a:t>
                      </a:r>
                      <a:r>
                        <a:rPr lang="de-AT" sz="1600" dirty="0"/>
                        <a:t>.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HEXIM1</a:t>
                      </a:r>
                      <a:r>
                        <a:rPr lang="de-AT" sz="1600" baseline="0" dirty="0">
                          <a:solidFill>
                            <a:schemeClr val="tx1"/>
                          </a:solidFill>
                        </a:rPr>
                        <a:t> modulation</a:t>
                      </a:r>
                      <a:r>
                        <a:rPr lang="de-AT" sz="1600" baseline="30000" dirty="0">
                          <a:solidFill>
                            <a:schemeClr val="tx1"/>
                          </a:solidFill>
                        </a:rPr>
                        <a:t>#</a:t>
                      </a:r>
                    </a:p>
                    <a:p>
                      <a:r>
                        <a:rPr lang="de-AT" sz="1600" baseline="0" dirty="0">
                          <a:solidFill>
                            <a:schemeClr val="tx1"/>
                          </a:solidFill>
                        </a:rPr>
                        <a:t>in tumor: 6 fold / in blood: 4.5-fold</a:t>
                      </a:r>
                      <a:endParaRPr lang="de-AT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6 (75%)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 gridSpan="2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BISans"/>
                        </a:defRPr>
                      </a:lvl9pPr>
                    </a:lstStyle>
                    <a:p>
                      <a:r>
                        <a:rPr lang="de-AT" sz="1600" dirty="0">
                          <a:solidFill>
                            <a:schemeClr val="tx1"/>
                          </a:solidFill>
                        </a:rPr>
                        <a:t>two deaths</a:t>
                      </a:r>
                    </a:p>
                  </a:txBody>
                  <a:tcPr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36699">
                        <a:tint val="2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5406695"/>
                  </a:ext>
                </a:extLst>
              </a:tr>
            </a:tbl>
          </a:graphicData>
        </a:graphic>
      </p:graphicFrame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44FB9B37-3106-44EA-82EE-11B29F8033F6}"/>
              </a:ext>
            </a:extLst>
          </p:cNvPr>
          <p:cNvGraphicFramePr>
            <a:graphicFrameLocks/>
          </p:cNvGraphicFramePr>
          <p:nvPr/>
        </p:nvGraphicFramePr>
        <p:xfrm>
          <a:off x="7121920" y="811593"/>
          <a:ext cx="3236640" cy="20614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1" name="Rectangle 30">
            <a:extLst>
              <a:ext uri="{FF2B5EF4-FFF2-40B4-BE49-F238E27FC236}">
                <a16:creationId xmlns:a16="http://schemas.microsoft.com/office/drawing/2014/main" id="{DD833A35-7B60-4C8A-82A8-5222F2EE05CE}"/>
              </a:ext>
            </a:extLst>
          </p:cNvPr>
          <p:cNvSpPr/>
          <p:nvPr/>
        </p:nvSpPr>
        <p:spPr>
          <a:xfrm>
            <a:off x="2314832" y="3661301"/>
            <a:ext cx="108779" cy="530465"/>
          </a:xfrm>
          <a:prstGeom prst="rect">
            <a:avLst/>
          </a:prstGeom>
          <a:solidFill>
            <a:srgbClr val="00FF00"/>
          </a:solidFill>
          <a:ln w="12700" cap="flat" cmpd="sng" algn="ctr">
            <a:noFill/>
            <a:prstDash val="solid"/>
          </a:ln>
          <a:effectLst/>
        </p:spPr>
        <p:txBody>
          <a:bodyPr lIns="96000" tIns="96000" rIns="96000" bIns="96000" rtlCol="0" anchor="ctr"/>
          <a:lstStyle/>
          <a:p>
            <a:pPr marL="0" marR="0" lvl="0" indent="0" algn="ctr" defTabSz="121917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AT" sz="1867" b="0" i="0" u="none" strike="noStrike" kern="0" cap="none" spc="0" normalizeH="0" baseline="0" noProof="0" dirty="0" err="1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ISans"/>
              <a:ea typeface="+mn-ea"/>
              <a:cs typeface="+mn-cs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6DC7F04-9344-4B54-B4C3-F7E194FFBC87}"/>
              </a:ext>
            </a:extLst>
          </p:cNvPr>
          <p:cNvSpPr/>
          <p:nvPr/>
        </p:nvSpPr>
        <p:spPr>
          <a:xfrm>
            <a:off x="2283968" y="4245864"/>
            <a:ext cx="139643" cy="688297"/>
          </a:xfrm>
          <a:prstGeom prst="rect">
            <a:avLst/>
          </a:prstGeom>
          <a:solidFill>
            <a:srgbClr val="0066FF"/>
          </a:solidFill>
          <a:ln w="12700" cap="flat" cmpd="sng" algn="ctr">
            <a:noFill/>
            <a:prstDash val="solid"/>
          </a:ln>
          <a:effectLst/>
        </p:spPr>
        <p:txBody>
          <a:bodyPr lIns="96000" tIns="96000" rIns="96000" bIns="96000" rtlCol="0" anchor="ctr"/>
          <a:lstStyle/>
          <a:p>
            <a:pPr marL="0" marR="0" lvl="0" indent="0" algn="ctr" defTabSz="121917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AT" sz="1867" b="0" i="0" u="none" strike="noStrike" kern="0" cap="none" spc="0" normalizeH="0" baseline="0" noProof="0" dirty="0" err="1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ISans"/>
              <a:ea typeface="+mn-ea"/>
              <a:cs typeface="+mn-cs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CAC4C99-4A4E-4FFE-9472-E300FD10A409}"/>
              </a:ext>
            </a:extLst>
          </p:cNvPr>
          <p:cNvSpPr/>
          <p:nvPr/>
        </p:nvSpPr>
        <p:spPr>
          <a:xfrm>
            <a:off x="2283968" y="4964404"/>
            <a:ext cx="139643" cy="577632"/>
          </a:xfrm>
          <a:prstGeom prst="rect">
            <a:avLst/>
          </a:prstGeom>
          <a:solidFill>
            <a:srgbClr val="C00000"/>
          </a:solidFill>
          <a:ln w="12700" cap="flat" cmpd="sng" algn="ctr">
            <a:noFill/>
            <a:prstDash val="solid"/>
          </a:ln>
          <a:effectLst/>
        </p:spPr>
        <p:txBody>
          <a:bodyPr lIns="96000" tIns="96000" rIns="96000" bIns="96000" rtlCol="0" anchor="ctr"/>
          <a:lstStyle/>
          <a:p>
            <a:pPr marL="0" marR="0" lvl="0" indent="0" algn="ctr" defTabSz="121917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AT" sz="1867" b="0" i="0" u="none" strike="noStrike" kern="0" cap="none" spc="0" normalizeH="0" baseline="0" noProof="0" dirty="0" err="1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BISans"/>
              <a:ea typeface="+mn-ea"/>
              <a:cs typeface="+mn-cs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1F8B19B-4D37-4F87-A122-E6272A91BDC9}"/>
              </a:ext>
            </a:extLst>
          </p:cNvPr>
          <p:cNvSpPr txBox="1"/>
          <p:nvPr/>
        </p:nvSpPr>
        <p:spPr>
          <a:xfrm>
            <a:off x="335052" y="183273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9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323A87D-7BB6-45EF-974B-5BA0C2401958}"/>
              </a:ext>
            </a:extLst>
          </p:cNvPr>
          <p:cNvSpPr txBox="1"/>
          <p:nvPr/>
        </p:nvSpPr>
        <p:spPr>
          <a:xfrm>
            <a:off x="7900877" y="1008504"/>
            <a:ext cx="1472767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377">
              <a:defRPr/>
            </a:pPr>
            <a:r>
              <a:rPr lang="de-AT" sz="1600" dirty="0">
                <a:solidFill>
                  <a:srgbClr val="000000"/>
                </a:solidFill>
                <a:latin typeface="BISansOpti"/>
              </a:rPr>
              <a:t>Ty-82 xenograf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6EC0053-4B9E-4B0C-B166-F54C4BFABBC9}"/>
              </a:ext>
            </a:extLst>
          </p:cNvPr>
          <p:cNvSpPr txBox="1"/>
          <p:nvPr/>
        </p:nvSpPr>
        <p:spPr>
          <a:xfrm>
            <a:off x="731195" y="2662777"/>
            <a:ext cx="1472767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377">
              <a:defRPr/>
            </a:pPr>
            <a:r>
              <a:rPr lang="de-AT" sz="1600" dirty="0">
                <a:solidFill>
                  <a:srgbClr val="000000"/>
                </a:solidFill>
                <a:latin typeface="BISansOpti"/>
              </a:rPr>
              <a:t>Ty-82 xenograft</a:t>
            </a:r>
          </a:p>
        </p:txBody>
      </p:sp>
    </p:spTree>
    <p:extLst>
      <p:ext uri="{BB962C8B-B14F-4D97-AF65-F5344CB8AC3E}">
        <p14:creationId xmlns:p14="http://schemas.microsoft.com/office/powerpoint/2010/main" val="20187413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848D269-7955-4A51-B1E5-5BAFEC01AFD7}"/>
              </a:ext>
            </a:extLst>
          </p:cNvPr>
          <p:cNvGraphicFramePr>
            <a:graphicFrameLocks noGrp="1"/>
          </p:cNvGraphicFramePr>
          <p:nvPr/>
        </p:nvGraphicFramePr>
        <p:xfrm>
          <a:off x="1392330" y="785347"/>
          <a:ext cx="5725160" cy="1535430"/>
        </p:xfrm>
        <a:graphic>
          <a:graphicData uri="http://schemas.openxmlformats.org/drawingml/2006/table">
            <a:tbl>
              <a:tblPr firstRow="1" firstCol="1" bandRow="1"/>
              <a:tblGrid>
                <a:gridCol w="953770">
                  <a:extLst>
                    <a:ext uri="{9D8B030D-6E8A-4147-A177-3AD203B41FA5}">
                      <a16:colId xmlns:a16="http://schemas.microsoft.com/office/drawing/2014/main" val="3092408729"/>
                    </a:ext>
                  </a:extLst>
                </a:gridCol>
                <a:gridCol w="953770">
                  <a:extLst>
                    <a:ext uri="{9D8B030D-6E8A-4147-A177-3AD203B41FA5}">
                      <a16:colId xmlns:a16="http://schemas.microsoft.com/office/drawing/2014/main" val="2318800586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601906226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4077986558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1614680718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145359836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ose [mg/kg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GI @ d17 [%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1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1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1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72869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02411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 8949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14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3926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73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62111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14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37758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 894999 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+ 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90998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 894999 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+ 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409062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E374220-14B1-4F5C-9D55-E41117FB37CB}"/>
              </a:ext>
            </a:extLst>
          </p:cNvPr>
          <p:cNvSpPr txBox="1"/>
          <p:nvPr/>
        </p:nvSpPr>
        <p:spPr>
          <a:xfrm>
            <a:off x="1392330" y="401217"/>
            <a:ext cx="58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Ty-82</a:t>
            </a:r>
            <a:endParaRPr lang="en-US" sz="1400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9902037-4C04-4A69-921F-4FEB7327F85E}"/>
              </a:ext>
            </a:extLst>
          </p:cNvPr>
          <p:cNvGraphicFramePr>
            <a:graphicFrameLocks noGrp="1"/>
          </p:cNvGraphicFramePr>
          <p:nvPr/>
        </p:nvGraphicFramePr>
        <p:xfrm>
          <a:off x="1392330" y="2795040"/>
          <a:ext cx="5725160" cy="1535430"/>
        </p:xfrm>
        <a:graphic>
          <a:graphicData uri="http://schemas.openxmlformats.org/drawingml/2006/table">
            <a:tbl>
              <a:tblPr firstRow="1" firstCol="1" bandRow="1"/>
              <a:tblGrid>
                <a:gridCol w="953770">
                  <a:extLst>
                    <a:ext uri="{9D8B030D-6E8A-4147-A177-3AD203B41FA5}">
                      <a16:colId xmlns:a16="http://schemas.microsoft.com/office/drawing/2014/main" val="887589595"/>
                    </a:ext>
                  </a:extLst>
                </a:gridCol>
                <a:gridCol w="953770">
                  <a:extLst>
                    <a:ext uri="{9D8B030D-6E8A-4147-A177-3AD203B41FA5}">
                      <a16:colId xmlns:a16="http://schemas.microsoft.com/office/drawing/2014/main" val="1911498181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2003411100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2406297662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1637172444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334168324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ose [mg/kg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GI @ d13 [%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1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1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1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147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0534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 8949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56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4217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42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61609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78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17330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 894999 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+ 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762667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 894999 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+ 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617432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65377D7-B250-4668-B132-BBDDEAC1FD9B}"/>
              </a:ext>
            </a:extLst>
          </p:cNvPr>
          <p:cNvSpPr txBox="1"/>
          <p:nvPr/>
        </p:nvSpPr>
        <p:spPr>
          <a:xfrm>
            <a:off x="1392330" y="2487263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10-15</a:t>
            </a:r>
            <a:endParaRPr lang="en-US" sz="1400" dirty="0"/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239D04BA-BBAA-48FB-B62D-2B4854C15623}"/>
              </a:ext>
            </a:extLst>
          </p:cNvPr>
          <p:cNvGraphicFramePr>
            <a:graphicFrameLocks noGrp="1"/>
          </p:cNvGraphicFramePr>
          <p:nvPr/>
        </p:nvGraphicFramePr>
        <p:xfrm>
          <a:off x="1392330" y="4804733"/>
          <a:ext cx="5725160" cy="1535430"/>
        </p:xfrm>
        <a:graphic>
          <a:graphicData uri="http://schemas.openxmlformats.org/drawingml/2006/table">
            <a:tbl>
              <a:tblPr firstRow="1" firstCol="1" bandRow="1"/>
              <a:tblGrid>
                <a:gridCol w="953770">
                  <a:extLst>
                    <a:ext uri="{9D8B030D-6E8A-4147-A177-3AD203B41FA5}">
                      <a16:colId xmlns:a16="http://schemas.microsoft.com/office/drawing/2014/main" val="3465896159"/>
                    </a:ext>
                  </a:extLst>
                </a:gridCol>
                <a:gridCol w="953770">
                  <a:extLst>
                    <a:ext uri="{9D8B030D-6E8A-4147-A177-3AD203B41FA5}">
                      <a16:colId xmlns:a16="http://schemas.microsoft.com/office/drawing/2014/main" val="111486681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1453472012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3657551987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3687323708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186016313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ose [mg/kg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GI @ d21 [%]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 value @ d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73187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kern="12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39944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 8949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28632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06048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  0.002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217664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 894999 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+ 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91347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 894999 +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S147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+ 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 0.00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9205029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9D4EBE1-4A57-458B-9304-53EDC93D9732}"/>
              </a:ext>
            </a:extLst>
          </p:cNvPr>
          <p:cNvSpPr txBox="1"/>
          <p:nvPr/>
        </p:nvSpPr>
        <p:spPr>
          <a:xfrm>
            <a:off x="1371363" y="4413713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10326</a:t>
            </a:r>
            <a:endParaRPr lang="en-US" sz="14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11A50F5-B694-4670-9294-DCCF1222F40A}"/>
              </a:ext>
            </a:extLst>
          </p:cNvPr>
          <p:cNvSpPr/>
          <p:nvPr/>
        </p:nvSpPr>
        <p:spPr>
          <a:xfrm>
            <a:off x="307673" y="77219"/>
            <a:ext cx="2038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Supplement Fig. 10 </a:t>
            </a:r>
          </a:p>
        </p:txBody>
      </p:sp>
    </p:spTree>
    <p:extLst>
      <p:ext uri="{BB962C8B-B14F-4D97-AF65-F5344CB8AC3E}">
        <p14:creationId xmlns:p14="http://schemas.microsoft.com/office/powerpoint/2010/main" val="27458415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EF44D21-C11D-42C4-8462-8C6B5270341F}"/>
              </a:ext>
            </a:extLst>
          </p:cNvPr>
          <p:cNvSpPr txBox="1"/>
          <p:nvPr/>
        </p:nvSpPr>
        <p:spPr>
          <a:xfrm>
            <a:off x="280592" y="113530"/>
            <a:ext cx="1985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11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128141F-320D-42CA-BC7B-9FBF6ACEBD5C}"/>
              </a:ext>
            </a:extLst>
          </p:cNvPr>
          <p:cNvGrpSpPr/>
          <p:nvPr/>
        </p:nvGrpSpPr>
        <p:grpSpPr>
          <a:xfrm>
            <a:off x="942976" y="576815"/>
            <a:ext cx="10338832" cy="4840739"/>
            <a:chOff x="942976" y="576815"/>
            <a:chExt cx="10338832" cy="484073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032A57F-E985-4070-8FAE-089B92CA5F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42976" y="576815"/>
              <a:ext cx="5010407" cy="2444876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E08EBB8-20BF-4863-90D9-E558ADD186B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87427" y="2972678"/>
              <a:ext cx="4921503" cy="244487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A913E09-142D-4261-9DC1-40E623BEE7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96000" y="2934578"/>
              <a:ext cx="4953255" cy="245757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42DEE25-E06B-4437-9EBF-63C997293F53}"/>
                </a:ext>
              </a:extLst>
            </p:cNvPr>
            <p:cNvSpPr txBox="1"/>
            <p:nvPr/>
          </p:nvSpPr>
          <p:spPr>
            <a:xfrm>
              <a:off x="4362995" y="992777"/>
              <a:ext cx="3098925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400" dirty="0"/>
                <a:t>2 mg/kg BI 894999</a:t>
              </a:r>
            </a:p>
            <a:p>
              <a:r>
                <a:rPr lang="de-AT" sz="1400" dirty="0"/>
                <a:t>2 mg/kg BI 894999 + 5 mg/kg CCS1477</a:t>
              </a:r>
            </a:p>
            <a:p>
              <a:r>
                <a:rPr lang="de-AT" sz="1400" dirty="0"/>
                <a:t>2 mg/kg BI 894999 + 10 mg/kg CCS1477</a:t>
              </a:r>
              <a:endParaRPr lang="en-US" sz="14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D2E026E-15FB-4706-96B8-220F98888E7E}"/>
                </a:ext>
              </a:extLst>
            </p:cNvPr>
            <p:cNvSpPr txBox="1"/>
            <p:nvPr/>
          </p:nvSpPr>
          <p:spPr>
            <a:xfrm>
              <a:off x="4493623" y="3361270"/>
              <a:ext cx="1595309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400" dirty="0"/>
                <a:t>5 mg/kg CCS1477</a:t>
              </a:r>
            </a:p>
            <a:p>
              <a:r>
                <a:rPr lang="de-AT" sz="1400" dirty="0"/>
                <a:t>5 mg/kg CCS1477 +</a:t>
              </a:r>
            </a:p>
            <a:p>
              <a:r>
                <a:rPr lang="de-AT" sz="1400" dirty="0"/>
                <a:t>2 mg/kg BI 894999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EFCF9FF-C860-44BB-994E-96DD03F822B7}"/>
                </a:ext>
              </a:extLst>
            </p:cNvPr>
            <p:cNvSpPr txBox="1"/>
            <p:nvPr/>
          </p:nvSpPr>
          <p:spPr>
            <a:xfrm>
              <a:off x="9595128" y="3300310"/>
              <a:ext cx="1686680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AT" sz="1400" dirty="0"/>
                <a:t>10 mg/kg CCS1477</a:t>
              </a:r>
            </a:p>
            <a:p>
              <a:r>
                <a:rPr lang="de-AT" sz="1400" dirty="0"/>
                <a:t>10 mg/kg CCS1477 +</a:t>
              </a:r>
            </a:p>
            <a:p>
              <a:r>
                <a:rPr lang="de-AT" sz="1400" dirty="0"/>
                <a:t>2 mg/kg BI 894999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5C0E437F-6EB6-4BD7-80EA-0D589F4DC9C7}"/>
                </a:ext>
              </a:extLst>
            </p:cNvPr>
            <p:cNvSpPr/>
            <p:nvPr/>
          </p:nvSpPr>
          <p:spPr>
            <a:xfrm>
              <a:off x="1584960" y="614460"/>
              <a:ext cx="2386149" cy="29404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FE87396A-7536-48C7-B1B9-9C7A133941B9}"/>
              </a:ext>
            </a:extLst>
          </p:cNvPr>
          <p:cNvSpPr/>
          <p:nvPr/>
        </p:nvSpPr>
        <p:spPr>
          <a:xfrm>
            <a:off x="1497873" y="3006268"/>
            <a:ext cx="2560321" cy="2940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585E13-319D-4B6B-9D3F-EED1F118051F}"/>
              </a:ext>
            </a:extLst>
          </p:cNvPr>
          <p:cNvSpPr/>
          <p:nvPr/>
        </p:nvSpPr>
        <p:spPr>
          <a:xfrm>
            <a:off x="6696891" y="2983436"/>
            <a:ext cx="2560321" cy="2940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549103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8155A29-6FAB-4DE1-A947-980DBB208E95}"/>
              </a:ext>
            </a:extLst>
          </p:cNvPr>
          <p:cNvSpPr txBox="1"/>
          <p:nvPr/>
        </p:nvSpPr>
        <p:spPr>
          <a:xfrm>
            <a:off x="152307" y="140351"/>
            <a:ext cx="1985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12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DAEBE169-62CC-491B-90FA-0ED9530D9239}"/>
              </a:ext>
            </a:extLst>
          </p:cNvPr>
          <p:cNvGrpSpPr/>
          <p:nvPr/>
        </p:nvGrpSpPr>
        <p:grpSpPr>
          <a:xfrm>
            <a:off x="740045" y="1254856"/>
            <a:ext cx="4623474" cy="3398679"/>
            <a:chOff x="740045" y="1254856"/>
            <a:chExt cx="4623474" cy="3398679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BB0961B1-0375-4001-A854-A1E9A8BBB72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40045" y="1254856"/>
            <a:ext cx="4623474" cy="339867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8" r:id="rId3" imgW="5537087" imgH="4070821" progId="Prism8.Document">
                    <p:embed/>
                  </p:oleObj>
                </mc:Choice>
                <mc:Fallback>
                  <p:oleObj name="Prism 8" r:id="rId3" imgW="5537087" imgH="4070821" progId="Prism8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BB0961B1-0375-4001-A854-A1E9A8BBB72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40045" y="1254856"/>
                          <a:ext cx="4623474" cy="339867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B145045-6DD2-4F93-8FEB-774E0CE5A90C}"/>
                </a:ext>
              </a:extLst>
            </p:cNvPr>
            <p:cNvSpPr/>
            <p:nvPr/>
          </p:nvSpPr>
          <p:spPr>
            <a:xfrm>
              <a:off x="965028" y="3298368"/>
              <a:ext cx="4042401" cy="999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407B05C-36AB-459F-A32D-BF5238779690}"/>
                </a:ext>
              </a:extLst>
            </p:cNvPr>
            <p:cNvSpPr txBox="1"/>
            <p:nvPr/>
          </p:nvSpPr>
          <p:spPr>
            <a:xfrm rot="18649495">
              <a:off x="1008050" y="3691860"/>
              <a:ext cx="9300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/>
                <a:t>Natrosol 0.5%</a:t>
              </a:r>
              <a:endParaRPr lang="en-US" sz="1000" b="1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6E362F5-00A1-4152-A7FE-EBF3B3A7C0CC}"/>
                </a:ext>
              </a:extLst>
            </p:cNvPr>
            <p:cNvSpPr txBox="1"/>
            <p:nvPr/>
          </p:nvSpPr>
          <p:spPr>
            <a:xfrm rot="18649495">
              <a:off x="1407897" y="3704619"/>
              <a:ext cx="1178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/>
                <a:t>2 mg/kg BI 894999</a:t>
              </a:r>
              <a:endParaRPr lang="en-US" sz="1000" b="1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559CA69-B23C-4457-B98F-6C8CFB2940D0}"/>
                </a:ext>
              </a:extLst>
            </p:cNvPr>
            <p:cNvSpPr txBox="1"/>
            <p:nvPr/>
          </p:nvSpPr>
          <p:spPr>
            <a:xfrm rot="18649495">
              <a:off x="2028194" y="3733500"/>
              <a:ext cx="11737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/>
                <a:t>10 mg/kg CCS1477</a:t>
              </a:r>
              <a:endParaRPr lang="en-US" sz="1000" b="1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BBAE04C-55C3-40B3-88D2-4F57ED18C6B0}"/>
                </a:ext>
              </a:extLst>
            </p:cNvPr>
            <p:cNvSpPr txBox="1"/>
            <p:nvPr/>
          </p:nvSpPr>
          <p:spPr>
            <a:xfrm rot="18649495">
              <a:off x="2741826" y="3723388"/>
              <a:ext cx="1107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/>
                <a:t>5 mg/kg CCS1477</a:t>
              </a:r>
              <a:endParaRPr lang="en-US" sz="10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4E6C806-5ED2-4ACA-8453-2C07CA07F4CA}"/>
                </a:ext>
              </a:extLst>
            </p:cNvPr>
            <p:cNvSpPr txBox="1"/>
            <p:nvPr/>
          </p:nvSpPr>
          <p:spPr>
            <a:xfrm rot="18649495">
              <a:off x="3339940" y="3698908"/>
              <a:ext cx="11785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/>
                <a:t>2 mg/kg BI 894999</a:t>
              </a:r>
            </a:p>
            <a:p>
              <a:r>
                <a:rPr lang="de-AT" sz="1000" b="1" dirty="0"/>
                <a:t>10 mg/kg CCS1477</a:t>
              </a:r>
              <a:endParaRPr lang="en-US" sz="1000" b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69B50CB-11DB-41CE-90F9-3413768DFF56}"/>
                </a:ext>
              </a:extLst>
            </p:cNvPr>
            <p:cNvSpPr txBox="1"/>
            <p:nvPr/>
          </p:nvSpPr>
          <p:spPr>
            <a:xfrm rot="18649495">
              <a:off x="3975425" y="3698907"/>
              <a:ext cx="11785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b="1" dirty="0"/>
                <a:t>2 mg/kg BI 894999</a:t>
              </a:r>
            </a:p>
            <a:p>
              <a:r>
                <a:rPr lang="de-AT" sz="1000" b="1" dirty="0"/>
                <a:t>5 mg/kg CCS1477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39492740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466A5F5-6D7F-4AC9-8253-8FA7F2DA9691}"/>
              </a:ext>
            </a:extLst>
          </p:cNvPr>
          <p:cNvGrpSpPr/>
          <p:nvPr/>
        </p:nvGrpSpPr>
        <p:grpSpPr>
          <a:xfrm>
            <a:off x="248028" y="1775663"/>
            <a:ext cx="11526878" cy="2387263"/>
            <a:chOff x="59376" y="2873610"/>
            <a:chExt cx="12073247" cy="2568815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09BCA76-D0E3-4772-94AB-B34596DEA34C}"/>
                </a:ext>
              </a:extLst>
            </p:cNvPr>
            <p:cNvSpPr txBox="1"/>
            <p:nvPr/>
          </p:nvSpPr>
          <p:spPr>
            <a:xfrm>
              <a:off x="110523" y="2901228"/>
              <a:ext cx="1931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7C4BCFB-9715-4C2B-842C-A61CD4391A94}"/>
                </a:ext>
              </a:extLst>
            </p:cNvPr>
            <p:cNvSpPr txBox="1"/>
            <p:nvPr/>
          </p:nvSpPr>
          <p:spPr>
            <a:xfrm>
              <a:off x="2098960" y="2873610"/>
              <a:ext cx="1934449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I 894999</a:t>
              </a:r>
            </a:p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 mg/Kg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C43A2F2-F537-40B4-B98E-C31E6E28A80F}"/>
                </a:ext>
              </a:extLst>
            </p:cNvPr>
            <p:cNvSpPr txBox="1"/>
            <p:nvPr/>
          </p:nvSpPr>
          <p:spPr>
            <a:xfrm>
              <a:off x="4107712" y="2891267"/>
              <a:ext cx="1913984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S1477 </a:t>
              </a:r>
            </a:p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 mg/Kg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CF35CCBE-A710-4D77-836D-C801D8D9F7E4}"/>
                </a:ext>
              </a:extLst>
            </p:cNvPr>
            <p:cNvGrpSpPr/>
            <p:nvPr/>
          </p:nvGrpSpPr>
          <p:grpSpPr>
            <a:xfrm>
              <a:off x="59376" y="3429000"/>
              <a:ext cx="12073247" cy="2013425"/>
              <a:chOff x="49756" y="3424293"/>
              <a:chExt cx="12192000" cy="1988955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765FFBF9-E18E-4AA2-83FC-9CE543B0ABF1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t="56379" r="56186" b="1845"/>
              <a:stretch/>
            </p:blipFill>
            <p:spPr>
              <a:xfrm>
                <a:off x="49756" y="3429000"/>
                <a:ext cx="2011680" cy="1984248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C71309C0-0B4A-4F53-A779-255FEA7D2DE5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954" t="28163" r="21241" b="356"/>
              <a:stretch/>
            </p:blipFill>
            <p:spPr>
              <a:xfrm>
                <a:off x="4098477" y="3424293"/>
                <a:ext cx="2011680" cy="1984248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EBE9FDE6-BB3D-4D90-A280-622E048BE441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t="23111" r="23110" b="2992"/>
              <a:stretch/>
            </p:blipFill>
            <p:spPr>
              <a:xfrm>
                <a:off x="6145756" y="3424293"/>
                <a:ext cx="2011680" cy="1984248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E10731C3-CC58-4ECD-9420-A0CABF26CA5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t="20295" r="15508" b="2087"/>
              <a:stretch/>
            </p:blipFill>
            <p:spPr>
              <a:xfrm>
                <a:off x="2061436" y="3424293"/>
                <a:ext cx="2011680" cy="1984248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CD580F83-ED13-4172-B7C5-827DD45CA54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50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t="7379" r="5200" b="13"/>
              <a:stretch/>
            </p:blipFill>
            <p:spPr>
              <a:xfrm>
                <a:off x="8193035" y="3424293"/>
                <a:ext cx="2011680" cy="1984248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BE560F18-B83D-4418-BD19-04AEF7712C4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2"/>
              <a:srcRect t="3781" r="6323"/>
              <a:stretch/>
            </p:blipFill>
            <p:spPr>
              <a:xfrm>
                <a:off x="10230076" y="3424293"/>
                <a:ext cx="2011680" cy="1984248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C832FC1-AF2C-4C4E-8389-277610029203}"/>
                </a:ext>
              </a:extLst>
            </p:cNvPr>
            <p:cNvSpPr txBox="1"/>
            <p:nvPr/>
          </p:nvSpPr>
          <p:spPr>
            <a:xfrm>
              <a:off x="6135051" y="2911635"/>
              <a:ext cx="1913984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S1477 </a:t>
              </a:r>
            </a:p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5 mg/Kg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E5470E5-0391-4A45-92C4-6DC370111726}"/>
                </a:ext>
              </a:extLst>
            </p:cNvPr>
            <p:cNvSpPr txBox="1"/>
            <p:nvPr/>
          </p:nvSpPr>
          <p:spPr>
            <a:xfrm>
              <a:off x="7648816" y="2926146"/>
              <a:ext cx="294113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I 894999 2 mg/Kg</a:t>
              </a:r>
            </a:p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S1477 10 mg/kg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7AE2036-3E68-44C5-B9F1-63AC429A2E92}"/>
                </a:ext>
              </a:extLst>
            </p:cNvPr>
            <p:cNvSpPr txBox="1"/>
            <p:nvPr/>
          </p:nvSpPr>
          <p:spPr>
            <a:xfrm>
              <a:off x="10162043" y="2919834"/>
              <a:ext cx="1949073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I 894999 2 mg/Kg</a:t>
              </a:r>
            </a:p>
            <a:p>
              <a:pPr algn="ctr"/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CS1477 5 mg/kg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4CED1AFD-EAA0-4414-BCFE-2B177D878988}"/>
              </a:ext>
            </a:extLst>
          </p:cNvPr>
          <p:cNvSpPr txBox="1"/>
          <p:nvPr/>
        </p:nvSpPr>
        <p:spPr>
          <a:xfrm>
            <a:off x="296860" y="21264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AT" dirty="0"/>
              <a:t>Supplement Fig. 13</a:t>
            </a:r>
          </a:p>
        </p:txBody>
      </p:sp>
    </p:spTree>
    <p:extLst>
      <p:ext uri="{BB962C8B-B14F-4D97-AF65-F5344CB8AC3E}">
        <p14:creationId xmlns:p14="http://schemas.microsoft.com/office/powerpoint/2010/main" val="7274144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885C27-ED35-46BC-96A4-0775DEC48618}"/>
              </a:ext>
            </a:extLst>
          </p:cNvPr>
          <p:cNvSpPr txBox="1"/>
          <p:nvPr/>
        </p:nvSpPr>
        <p:spPr>
          <a:xfrm>
            <a:off x="277891" y="137174"/>
            <a:ext cx="20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14 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35372FEB-9889-43C8-92B5-172980428851}"/>
              </a:ext>
            </a:extLst>
          </p:cNvPr>
          <p:cNvGrpSpPr/>
          <p:nvPr/>
        </p:nvGrpSpPr>
        <p:grpSpPr>
          <a:xfrm>
            <a:off x="129915" y="1031318"/>
            <a:ext cx="11598392" cy="4397979"/>
            <a:chOff x="120584" y="564787"/>
            <a:chExt cx="11598392" cy="439797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24D0059-C11D-411E-95BF-CF55DE7CEF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8384" y="659422"/>
              <a:ext cx="3835597" cy="4007056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3031DE5-74C6-4091-90C5-1E3193C05D77}"/>
                </a:ext>
              </a:extLst>
            </p:cNvPr>
            <p:cNvSpPr txBox="1"/>
            <p:nvPr/>
          </p:nvSpPr>
          <p:spPr>
            <a:xfrm>
              <a:off x="198384" y="2427141"/>
              <a:ext cx="599317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                       CCS1477  [nmol/l]              </a:t>
              </a:r>
              <a:endParaRPr lang="en-US" sz="10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D454BCF-30F1-4BF2-859B-B64B4724B04D}"/>
                </a:ext>
              </a:extLst>
            </p:cNvPr>
            <p:cNvSpPr txBox="1"/>
            <p:nvPr/>
          </p:nvSpPr>
          <p:spPr>
            <a:xfrm>
              <a:off x="289001" y="4506985"/>
              <a:ext cx="599317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                       CCS1477  [nmol/l]              </a:t>
              </a:r>
              <a:endParaRPr lang="en-US" sz="10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4E32106-86C7-46C6-916B-04DBE79561F8}"/>
                </a:ext>
              </a:extLst>
            </p:cNvPr>
            <p:cNvSpPr txBox="1"/>
            <p:nvPr/>
          </p:nvSpPr>
          <p:spPr>
            <a:xfrm rot="16200000">
              <a:off x="-896587" y="3690533"/>
              <a:ext cx="2289404" cy="25506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BI 894999  [nmol/l]              </a:t>
              </a:r>
              <a:endParaRPr lang="en-US" sz="10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57149F9-8604-466F-B27C-3FEB7EB38F00}"/>
                </a:ext>
              </a:extLst>
            </p:cNvPr>
            <p:cNvSpPr txBox="1"/>
            <p:nvPr/>
          </p:nvSpPr>
          <p:spPr>
            <a:xfrm rot="16200000">
              <a:off x="-876141" y="1626526"/>
              <a:ext cx="2289404" cy="25506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BI 894999  [nmol/l]              </a:t>
              </a:r>
              <a:endParaRPr lang="en-US" sz="1000" dirty="0"/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199F51F-9189-4D13-B7CD-3374CC64C8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11679" y="677738"/>
              <a:ext cx="3626036" cy="3829247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C71470D-ABD3-4197-BDA8-E10819F9AF08}"/>
                </a:ext>
              </a:extLst>
            </p:cNvPr>
            <p:cNvSpPr txBox="1"/>
            <p:nvPr/>
          </p:nvSpPr>
          <p:spPr>
            <a:xfrm>
              <a:off x="4119321" y="4526261"/>
              <a:ext cx="599317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                       CCS1477  [nmol/l]              </a:t>
              </a:r>
              <a:endParaRPr lang="en-US" sz="10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4C4F9F0-AB2A-48BA-B94B-F63F19E39DE1}"/>
                </a:ext>
              </a:extLst>
            </p:cNvPr>
            <p:cNvSpPr txBox="1"/>
            <p:nvPr/>
          </p:nvSpPr>
          <p:spPr>
            <a:xfrm>
              <a:off x="4109160" y="2461313"/>
              <a:ext cx="599317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                       CCS1477  [nmol/l]              </a:t>
              </a:r>
              <a:endParaRPr lang="en-US" sz="1000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EC285C8-07F6-4945-96BA-D22708914AEE}"/>
                </a:ext>
              </a:extLst>
            </p:cNvPr>
            <p:cNvSpPr/>
            <p:nvPr/>
          </p:nvSpPr>
          <p:spPr>
            <a:xfrm>
              <a:off x="5781040" y="609355"/>
              <a:ext cx="720901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4534261-737B-461D-850A-AC097AB01B0B}"/>
                </a:ext>
              </a:extLst>
            </p:cNvPr>
            <p:cNvSpPr/>
            <p:nvPr/>
          </p:nvSpPr>
          <p:spPr>
            <a:xfrm>
              <a:off x="6352843" y="2703597"/>
              <a:ext cx="720901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E035181D-5681-44C7-B141-2082C12A498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83762" y="659421"/>
              <a:ext cx="3635214" cy="386683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F70A689-B640-47F2-8E6B-72C705412247}"/>
                </a:ext>
              </a:extLst>
            </p:cNvPr>
            <p:cNvSpPr txBox="1"/>
            <p:nvPr/>
          </p:nvSpPr>
          <p:spPr>
            <a:xfrm>
              <a:off x="8158479" y="2459871"/>
              <a:ext cx="352567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                       CCS1477  [nmol/l]              </a:t>
              </a:r>
              <a:endParaRPr lang="en-US" sz="10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CF62D78-C413-4516-9824-46A3922F074B}"/>
                </a:ext>
              </a:extLst>
            </p:cNvPr>
            <p:cNvSpPr txBox="1"/>
            <p:nvPr/>
          </p:nvSpPr>
          <p:spPr>
            <a:xfrm>
              <a:off x="8138530" y="4505443"/>
              <a:ext cx="352567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AT" sz="1000" dirty="0"/>
                <a:t>                                                 CCS1477  [nmol/l]              </a:t>
              </a:r>
              <a:endParaRPr lang="en-US" sz="1000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4225B00-45EA-4CFE-A02F-93A0F39D3A58}"/>
                </a:ext>
              </a:extLst>
            </p:cNvPr>
            <p:cNvSpPr/>
            <p:nvPr/>
          </p:nvSpPr>
          <p:spPr>
            <a:xfrm>
              <a:off x="9418928" y="564787"/>
              <a:ext cx="720901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A9FD2A91-FA23-4BAA-936E-606C598CB3AC}"/>
                </a:ext>
              </a:extLst>
            </p:cNvPr>
            <p:cNvSpPr/>
            <p:nvPr/>
          </p:nvSpPr>
          <p:spPr>
            <a:xfrm>
              <a:off x="9961957" y="2699624"/>
              <a:ext cx="720901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94552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6153790-7CF3-4C1E-AF66-8ED33D6BB9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3310" y="972502"/>
            <a:ext cx="4762500" cy="35718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F9B1DD5-BA90-42E0-B2C2-F2497C55FAE3}"/>
              </a:ext>
            </a:extLst>
          </p:cNvPr>
          <p:cNvSpPr txBox="1"/>
          <p:nvPr/>
        </p:nvSpPr>
        <p:spPr>
          <a:xfrm>
            <a:off x="2769370" y="603170"/>
            <a:ext cx="6951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Ty-82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2C3478-A882-4BFD-AEFF-AC9CCA32DECE}"/>
              </a:ext>
            </a:extLst>
          </p:cNvPr>
          <p:cNvSpPr txBox="1"/>
          <p:nvPr/>
        </p:nvSpPr>
        <p:spPr>
          <a:xfrm>
            <a:off x="2499360" y="4661780"/>
            <a:ext cx="219002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>
                <a:solidFill>
                  <a:srgbClr val="FF0000"/>
                </a:solidFill>
              </a:rPr>
              <a:t>BI 894999: GI</a:t>
            </a:r>
            <a:r>
              <a:rPr lang="de-AT" sz="1400" baseline="-25000" dirty="0">
                <a:solidFill>
                  <a:srgbClr val="FF0000"/>
                </a:solidFill>
              </a:rPr>
              <a:t>50</a:t>
            </a:r>
            <a:r>
              <a:rPr lang="de-AT" sz="1400" dirty="0">
                <a:solidFill>
                  <a:srgbClr val="FF0000"/>
                </a:solidFill>
              </a:rPr>
              <a:t> 2.1 nM</a:t>
            </a:r>
          </a:p>
          <a:p>
            <a:r>
              <a:rPr lang="de-AT" sz="1400" dirty="0">
                <a:solidFill>
                  <a:srgbClr val="0000FF"/>
                </a:solidFill>
              </a:rPr>
              <a:t>JQ1: GI</a:t>
            </a:r>
            <a:r>
              <a:rPr lang="de-AT" sz="1400" baseline="-25000" dirty="0">
                <a:solidFill>
                  <a:srgbClr val="0000FF"/>
                </a:solidFill>
              </a:rPr>
              <a:t>50 </a:t>
            </a:r>
            <a:r>
              <a:rPr lang="de-AT" sz="1400" dirty="0">
                <a:solidFill>
                  <a:srgbClr val="0000FF"/>
                </a:solidFill>
              </a:rPr>
              <a:t>99.1 nM</a:t>
            </a:r>
          </a:p>
          <a:p>
            <a:r>
              <a:rPr lang="de-AT" sz="1400" dirty="0">
                <a:solidFill>
                  <a:srgbClr val="00B050"/>
                </a:solidFill>
              </a:rPr>
              <a:t>GSK525762: GI</a:t>
            </a:r>
            <a:r>
              <a:rPr lang="de-AT" sz="1400" baseline="-25000" dirty="0">
                <a:solidFill>
                  <a:srgbClr val="00B050"/>
                </a:solidFill>
              </a:rPr>
              <a:t>50</a:t>
            </a:r>
            <a:r>
              <a:rPr lang="de-AT" sz="1400" dirty="0">
                <a:solidFill>
                  <a:srgbClr val="00B050"/>
                </a:solidFill>
              </a:rPr>
              <a:t> 155.2 nM</a:t>
            </a:r>
          </a:p>
          <a:p>
            <a:endParaRPr lang="en-US" sz="1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220021A-A9AC-4654-941F-3264B888FE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1544" y="972502"/>
            <a:ext cx="4762500" cy="357187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9427ABF-99A0-431E-AF5D-AE64C5EEC4A5}"/>
              </a:ext>
            </a:extLst>
          </p:cNvPr>
          <p:cNvSpPr txBox="1"/>
          <p:nvPr/>
        </p:nvSpPr>
        <p:spPr>
          <a:xfrm>
            <a:off x="7917604" y="68429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0-15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D96F1B-A3BF-4479-83EE-C8F3B0B449C0}"/>
              </a:ext>
            </a:extLst>
          </p:cNvPr>
          <p:cNvSpPr txBox="1"/>
          <p:nvPr/>
        </p:nvSpPr>
        <p:spPr>
          <a:xfrm>
            <a:off x="7319010" y="4637729"/>
            <a:ext cx="219002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>
                <a:solidFill>
                  <a:srgbClr val="FF0000"/>
                </a:solidFill>
              </a:rPr>
              <a:t>BI 894999: GI</a:t>
            </a:r>
            <a:r>
              <a:rPr lang="de-AT" sz="1400" baseline="-25000" dirty="0">
                <a:solidFill>
                  <a:srgbClr val="FF0000"/>
                </a:solidFill>
              </a:rPr>
              <a:t>50</a:t>
            </a:r>
            <a:r>
              <a:rPr lang="de-AT" sz="1400" dirty="0">
                <a:solidFill>
                  <a:srgbClr val="FF0000"/>
                </a:solidFill>
              </a:rPr>
              <a:t> 2.1 nM</a:t>
            </a:r>
          </a:p>
          <a:p>
            <a:r>
              <a:rPr lang="de-AT" sz="1400" dirty="0">
                <a:solidFill>
                  <a:srgbClr val="0000FF"/>
                </a:solidFill>
              </a:rPr>
              <a:t>JQ1: GI</a:t>
            </a:r>
            <a:r>
              <a:rPr lang="de-AT" sz="1400" baseline="-25000" dirty="0">
                <a:solidFill>
                  <a:srgbClr val="0000FF"/>
                </a:solidFill>
              </a:rPr>
              <a:t>50</a:t>
            </a:r>
            <a:r>
              <a:rPr lang="de-AT" sz="1400" dirty="0">
                <a:solidFill>
                  <a:srgbClr val="0000FF"/>
                </a:solidFill>
              </a:rPr>
              <a:t> 92.6 nM</a:t>
            </a:r>
          </a:p>
          <a:p>
            <a:r>
              <a:rPr lang="de-AT" sz="1400" dirty="0">
                <a:solidFill>
                  <a:srgbClr val="00B050"/>
                </a:solidFill>
              </a:rPr>
              <a:t>GSK525762: GI</a:t>
            </a:r>
            <a:r>
              <a:rPr lang="de-AT" sz="1400" baseline="-25000" dirty="0">
                <a:solidFill>
                  <a:srgbClr val="00B050"/>
                </a:solidFill>
              </a:rPr>
              <a:t>50</a:t>
            </a:r>
            <a:r>
              <a:rPr lang="de-AT" sz="1400" dirty="0">
                <a:solidFill>
                  <a:srgbClr val="00B050"/>
                </a:solidFill>
              </a:rPr>
              <a:t> 106.8 nM</a:t>
            </a:r>
          </a:p>
          <a:p>
            <a:endParaRPr lang="en-US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D54324C-E7BB-409B-B6EB-717EF9694CFD}"/>
              </a:ext>
            </a:extLst>
          </p:cNvPr>
          <p:cNvSpPr txBox="1"/>
          <p:nvPr/>
        </p:nvSpPr>
        <p:spPr>
          <a:xfrm>
            <a:off x="490099" y="212368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2</a:t>
            </a:r>
          </a:p>
        </p:txBody>
      </p:sp>
    </p:spTree>
    <p:extLst>
      <p:ext uri="{BB962C8B-B14F-4D97-AF65-F5344CB8AC3E}">
        <p14:creationId xmlns:p14="http://schemas.microsoft.com/office/powerpoint/2010/main" val="3041433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832AC3D1-F407-49D6-AF9B-BD99360B87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7497" y="3733345"/>
            <a:ext cx="3512038" cy="2150014"/>
          </a:xfrm>
          <a:prstGeom prst="rect">
            <a:avLst/>
          </a:prstGeom>
        </p:spPr>
      </p:pic>
      <p:sp>
        <p:nvSpPr>
          <p:cNvPr id="3" name="Slide Number Placeholder 3">
            <a:extLst>
              <a:ext uri="{FF2B5EF4-FFF2-40B4-BE49-F238E27FC236}">
                <a16:creationId xmlns:a16="http://schemas.microsoft.com/office/drawing/2014/main" id="{CDBD516B-4533-4E0C-8306-E17F0A7F1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554425" y="6597269"/>
            <a:ext cx="147476" cy="153888"/>
          </a:xfrm>
        </p:spPr>
        <p:txBody>
          <a:bodyPr/>
          <a:lstStyle/>
          <a:p>
            <a:pPr defTabSz="1219170"/>
            <a:fld id="{143B55C4-4F5A-416B-997D-6CE47EB0A945}" type="slidenum">
              <a:rPr lang="en-GB">
                <a:solidFill>
                  <a:prstClr val="white">
                    <a:lumMod val="50000"/>
                  </a:prstClr>
                </a:solidFill>
              </a:rPr>
              <a:pPr defTabSz="1219170"/>
              <a:t>3</a:t>
            </a:fld>
            <a:endParaRPr lang="en-GB" dirty="0">
              <a:solidFill>
                <a:prstClr val="white">
                  <a:lumMod val="50000"/>
                </a:prstClr>
              </a:solidFill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9970142-20FF-4073-A749-604DC13A2C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2911" y="1174690"/>
            <a:ext cx="3601368" cy="245222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C5AB4C1-9CBC-4139-877E-CF0BF20A1F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19190" y="1190227"/>
            <a:ext cx="3601367" cy="24366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3098804-D0C4-4EAC-92AA-BADEF7BA4E2B}"/>
              </a:ext>
            </a:extLst>
          </p:cNvPr>
          <p:cNvSpPr txBox="1"/>
          <p:nvPr/>
        </p:nvSpPr>
        <p:spPr>
          <a:xfrm>
            <a:off x="7019630" y="2298305"/>
            <a:ext cx="49212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1F497D"/>
                </a:solidFill>
                <a:latin typeface="BISansOpti"/>
              </a:rPr>
              <a:t>10 µ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5F9D7B-7186-47EF-AB20-4D2D35DD7EDE}"/>
              </a:ext>
            </a:extLst>
          </p:cNvPr>
          <p:cNvSpPr txBox="1"/>
          <p:nvPr/>
        </p:nvSpPr>
        <p:spPr>
          <a:xfrm>
            <a:off x="7425689" y="2713821"/>
            <a:ext cx="39594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990033"/>
                </a:solidFill>
                <a:latin typeface="BISansOpti"/>
              </a:rPr>
              <a:t>3 µ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98E117-0528-4ADE-9727-E5A1404D7998}"/>
              </a:ext>
            </a:extLst>
          </p:cNvPr>
          <p:cNvSpPr txBox="1"/>
          <p:nvPr/>
        </p:nvSpPr>
        <p:spPr>
          <a:xfrm>
            <a:off x="5118760" y="2719021"/>
            <a:ext cx="49013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1F497D"/>
                </a:solidFill>
                <a:latin typeface="BISansOpti"/>
              </a:rPr>
              <a:t>10 n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9F6C9E4-5A89-418D-AE5C-16DCD6B7D533}"/>
              </a:ext>
            </a:extLst>
          </p:cNvPr>
          <p:cNvSpPr txBox="1"/>
          <p:nvPr/>
        </p:nvSpPr>
        <p:spPr>
          <a:xfrm>
            <a:off x="5118760" y="2902357"/>
            <a:ext cx="49013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FF9900"/>
                </a:solidFill>
                <a:latin typeface="BISansOpti"/>
              </a:rPr>
              <a:t>30 n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A94925-0E10-4785-AACA-2E4ECA291886}"/>
              </a:ext>
            </a:extLst>
          </p:cNvPr>
          <p:cNvSpPr txBox="1"/>
          <p:nvPr/>
        </p:nvSpPr>
        <p:spPr>
          <a:xfrm>
            <a:off x="7425689" y="4617740"/>
            <a:ext cx="58952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0000FF"/>
                </a:solidFill>
                <a:latin typeface="BISansOpti"/>
              </a:rPr>
              <a:t>100 n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5A986C-B044-4264-937F-FDFFB18AD5E0}"/>
              </a:ext>
            </a:extLst>
          </p:cNvPr>
          <p:cNvSpPr txBox="1"/>
          <p:nvPr/>
        </p:nvSpPr>
        <p:spPr>
          <a:xfrm>
            <a:off x="7821631" y="4794962"/>
            <a:ext cx="49173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123563"/>
                </a:solidFill>
                <a:latin typeface="BISansOpti"/>
              </a:rPr>
              <a:t>33 n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876C652-F50E-4B02-BC83-082526DF278A}"/>
              </a:ext>
            </a:extLst>
          </p:cNvPr>
          <p:cNvSpPr txBox="1"/>
          <p:nvPr/>
        </p:nvSpPr>
        <p:spPr>
          <a:xfrm>
            <a:off x="5117936" y="5469261"/>
            <a:ext cx="58791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0000FF"/>
                </a:solidFill>
                <a:latin typeface="BISansOpti"/>
              </a:rPr>
              <a:t>100 n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067BC26-B15F-44E0-849A-ABF468E33530}"/>
              </a:ext>
            </a:extLst>
          </p:cNvPr>
          <p:cNvSpPr txBox="1"/>
          <p:nvPr/>
        </p:nvSpPr>
        <p:spPr>
          <a:xfrm>
            <a:off x="5143200" y="5257817"/>
            <a:ext cx="49013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123563"/>
                </a:solidFill>
                <a:latin typeface="BISansOpti"/>
              </a:rPr>
              <a:t>33 n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92A6437-780A-4460-9835-88455AFE8B9B}"/>
              </a:ext>
            </a:extLst>
          </p:cNvPr>
          <p:cNvSpPr txBox="1"/>
          <p:nvPr/>
        </p:nvSpPr>
        <p:spPr>
          <a:xfrm>
            <a:off x="5143200" y="4947649"/>
            <a:ext cx="49013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400" dirty="0">
                <a:solidFill>
                  <a:srgbClr val="990033"/>
                </a:solidFill>
                <a:latin typeface="BISansOpti"/>
              </a:rPr>
              <a:t>11 n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D7FE036-68E5-43EB-B151-451671CE71FB}"/>
              </a:ext>
            </a:extLst>
          </p:cNvPr>
          <p:cNvSpPr txBox="1"/>
          <p:nvPr/>
        </p:nvSpPr>
        <p:spPr>
          <a:xfrm>
            <a:off x="537730" y="1856653"/>
            <a:ext cx="719043" cy="5746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219170"/>
            <a:r>
              <a:rPr lang="de-AT" sz="1867" dirty="0">
                <a:solidFill>
                  <a:prstClr val="black"/>
                </a:solidFill>
                <a:latin typeface="BISans"/>
              </a:rPr>
              <a:t>NC </a:t>
            </a:r>
          </a:p>
          <a:p>
            <a:pPr defTabSz="1219170"/>
            <a:r>
              <a:rPr lang="de-AT" sz="1867" dirty="0">
                <a:solidFill>
                  <a:prstClr val="black"/>
                </a:solidFill>
                <a:latin typeface="BISans"/>
              </a:rPr>
              <a:t>(Ty-82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ADCAC8-68B6-4A74-9D53-E578B2E03249}"/>
              </a:ext>
            </a:extLst>
          </p:cNvPr>
          <p:cNvSpPr txBox="1"/>
          <p:nvPr/>
        </p:nvSpPr>
        <p:spPr>
          <a:xfrm>
            <a:off x="537730" y="4166626"/>
            <a:ext cx="1055610" cy="5746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219170"/>
            <a:r>
              <a:rPr lang="de-AT" sz="1867" dirty="0">
                <a:solidFill>
                  <a:prstClr val="black"/>
                </a:solidFill>
                <a:latin typeface="BISans"/>
              </a:rPr>
              <a:t>AML</a:t>
            </a:r>
          </a:p>
          <a:p>
            <a:pPr defTabSz="1219170"/>
            <a:r>
              <a:rPr lang="de-AT" sz="1867" dirty="0">
                <a:solidFill>
                  <a:prstClr val="black"/>
                </a:solidFill>
                <a:latin typeface="BISans"/>
              </a:rPr>
              <a:t>(MV-4-11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7A6C1A-EF03-4B20-A86E-A36C2CD75E56}"/>
              </a:ext>
            </a:extLst>
          </p:cNvPr>
          <p:cNvSpPr txBox="1"/>
          <p:nvPr/>
        </p:nvSpPr>
        <p:spPr>
          <a:xfrm>
            <a:off x="10035690" y="4035286"/>
            <a:ext cx="1552028" cy="92333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Full growth inhibition </a:t>
            </a:r>
          </a:p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at ~10 - 30 nM </a:t>
            </a:r>
          </a:p>
          <a:p>
            <a:pPr defTabSz="914377"/>
            <a:endParaRPr lang="de-AT" sz="1200" dirty="0">
              <a:solidFill>
                <a:srgbClr val="000000"/>
              </a:solidFill>
              <a:latin typeface="BISansOpti"/>
            </a:endParaRPr>
          </a:p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Induction of apoptosis </a:t>
            </a:r>
          </a:p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at ~10 - 30 n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67E9590-222D-475B-B189-D9DB5101B669}"/>
              </a:ext>
            </a:extLst>
          </p:cNvPr>
          <p:cNvSpPr txBox="1"/>
          <p:nvPr/>
        </p:nvSpPr>
        <p:spPr>
          <a:xfrm>
            <a:off x="2632971" y="917335"/>
            <a:ext cx="11485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377"/>
            <a:r>
              <a:rPr lang="de-AT" sz="1400" dirty="0">
                <a:solidFill>
                  <a:srgbClr val="000000"/>
                </a:solidFill>
                <a:latin typeface="BISansOpti"/>
              </a:rPr>
              <a:t>Proliferat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85E6BC8-B0E6-4518-9719-73CFAA8F3E3C}"/>
              </a:ext>
            </a:extLst>
          </p:cNvPr>
          <p:cNvSpPr txBox="1"/>
          <p:nvPr/>
        </p:nvSpPr>
        <p:spPr>
          <a:xfrm>
            <a:off x="6812210" y="886904"/>
            <a:ext cx="26135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77"/>
            <a:r>
              <a:rPr lang="de-AT" sz="1400" dirty="0">
                <a:solidFill>
                  <a:srgbClr val="000000"/>
                </a:solidFill>
                <a:latin typeface="BISansOpti"/>
              </a:rPr>
              <a:t>Apoptosis (Caspase 3/7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88D78EE-E862-4C00-8A28-C39BBFCB168E}"/>
              </a:ext>
            </a:extLst>
          </p:cNvPr>
          <p:cNvSpPr txBox="1"/>
          <p:nvPr/>
        </p:nvSpPr>
        <p:spPr>
          <a:xfrm>
            <a:off x="9982008" y="1682310"/>
            <a:ext cx="4419983" cy="92333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Full growth inhibition </a:t>
            </a:r>
          </a:p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at ~10 - 30 nM </a:t>
            </a:r>
          </a:p>
          <a:p>
            <a:pPr defTabSz="914377"/>
            <a:endParaRPr lang="de-AT" sz="1200" dirty="0">
              <a:solidFill>
                <a:srgbClr val="000000"/>
              </a:solidFill>
              <a:latin typeface="BISansOpti"/>
            </a:endParaRPr>
          </a:p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Induction of apoptosis </a:t>
            </a:r>
          </a:p>
          <a:p>
            <a:pPr defTabSz="914377"/>
            <a:r>
              <a:rPr lang="de-AT" sz="1200" dirty="0">
                <a:solidFill>
                  <a:srgbClr val="000000"/>
                </a:solidFill>
                <a:latin typeface="BISansOpti"/>
              </a:rPr>
              <a:t>at ~3000 – 10000 nM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4AC7F99-B147-4BF6-B808-80A31ACD7ADA}"/>
              </a:ext>
            </a:extLst>
          </p:cNvPr>
          <p:cNvSpPr txBox="1"/>
          <p:nvPr/>
        </p:nvSpPr>
        <p:spPr>
          <a:xfrm>
            <a:off x="418402" y="239971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01E4341-C975-49B7-931F-12ECC822A1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0396" y="3748629"/>
            <a:ext cx="3404296" cy="21691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58377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365" y="1002082"/>
            <a:ext cx="2850258" cy="5743184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939452" y="588723"/>
            <a:ext cx="114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control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2514" y="1007733"/>
            <a:ext cx="2847453" cy="5737533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3768166" y="588723"/>
            <a:ext cx="1616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nM BI4999</a:t>
            </a: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858" y="1002082"/>
            <a:ext cx="2850258" cy="5743184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6743913" y="588723"/>
            <a:ext cx="17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10nM BI4999</a:t>
            </a: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1202" y="1002082"/>
            <a:ext cx="2850258" cy="5743184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9836679" y="632750"/>
            <a:ext cx="17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0nM BI4999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400041" y="112734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/>
              <a:t>NC 1032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BFF9F4-A274-40F0-9E34-AD8A224B8CCE}"/>
              </a:ext>
            </a:extLst>
          </p:cNvPr>
          <p:cNvSpPr txBox="1"/>
          <p:nvPr/>
        </p:nvSpPr>
        <p:spPr>
          <a:xfrm>
            <a:off x="293863" y="-6198"/>
            <a:ext cx="20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4 A</a:t>
            </a:r>
          </a:p>
        </p:txBody>
      </p:sp>
    </p:spTree>
    <p:extLst>
      <p:ext uri="{BB962C8B-B14F-4D97-AF65-F5344CB8AC3E}">
        <p14:creationId xmlns:p14="http://schemas.microsoft.com/office/powerpoint/2010/main" val="4893839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384314" y="133332"/>
            <a:ext cx="1050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/>
              <a:t>NC 10-15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939452" y="588723"/>
            <a:ext cx="114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control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3768166" y="588723"/>
            <a:ext cx="1616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nM BI4999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6743913" y="588723"/>
            <a:ext cx="17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10nM BI4999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9836679" y="632750"/>
            <a:ext cx="17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0nM BI4999</a:t>
            </a:r>
          </a:p>
        </p:txBody>
      </p:sp>
      <p:pic>
        <p:nvPicPr>
          <p:cNvPr id="15" name="Grafik 14" descr="Ein Bild, das Text, Anzeige enthält.&#10;&#10;Automatisch generierte Beschreibung">
            <a:extLst>
              <a:ext uri="{FF2B5EF4-FFF2-40B4-BE49-F238E27FC236}">
                <a16:creationId xmlns:a16="http://schemas.microsoft.com/office/drawing/2014/main" id="{980FD303-7C6A-45F9-B00A-88A65E6B06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8175" y="1002082"/>
            <a:ext cx="2837825" cy="5718132"/>
          </a:xfrm>
          <a:prstGeom prst="rect">
            <a:avLst/>
          </a:prstGeom>
        </p:spPr>
      </p:pic>
      <p:pic>
        <p:nvPicPr>
          <p:cNvPr id="19" name="Grafik 18" descr="Ein Bild, das Nachthimmel enthält.&#10;&#10;Automatisch generierte Beschreibung">
            <a:extLst>
              <a:ext uri="{FF2B5EF4-FFF2-40B4-BE49-F238E27FC236}">
                <a16:creationId xmlns:a16="http://schemas.microsoft.com/office/drawing/2014/main" id="{DBF43877-EEBF-4C68-869E-417E5E66AA1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6069" y="1002082"/>
            <a:ext cx="2837825" cy="5718132"/>
          </a:xfrm>
          <a:prstGeom prst="rect">
            <a:avLst/>
          </a:prstGeom>
        </p:spPr>
      </p:pic>
      <p:pic>
        <p:nvPicPr>
          <p:cNvPr id="10" name="Grafik 9" descr="Ein Bild, das Hohltiere enthält.&#10;&#10;Automatisch generierte Beschreibung">
            <a:extLst>
              <a:ext uri="{FF2B5EF4-FFF2-40B4-BE49-F238E27FC236}">
                <a16:creationId xmlns:a16="http://schemas.microsoft.com/office/drawing/2014/main" id="{5B357C1A-908C-4B14-90B9-745A51A6408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4926" y="1002081"/>
            <a:ext cx="2837825" cy="5718133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3197FB75-99A3-44DC-859B-31A2692E568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031" y="1002081"/>
            <a:ext cx="2837825" cy="571813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6821274-9508-44EB-8032-5EC4AE522595}"/>
              </a:ext>
            </a:extLst>
          </p:cNvPr>
          <p:cNvSpPr txBox="1"/>
          <p:nvPr/>
        </p:nvSpPr>
        <p:spPr>
          <a:xfrm>
            <a:off x="293863" y="-6198"/>
            <a:ext cx="20468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4 B</a:t>
            </a:r>
          </a:p>
        </p:txBody>
      </p:sp>
    </p:spTree>
    <p:extLst>
      <p:ext uri="{BB962C8B-B14F-4D97-AF65-F5344CB8AC3E}">
        <p14:creationId xmlns:p14="http://schemas.microsoft.com/office/powerpoint/2010/main" val="12495923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5389724" y="100288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/>
              <a:t>NC 14169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939452" y="588723"/>
            <a:ext cx="114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contro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768166" y="588723"/>
            <a:ext cx="1616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nM BI4999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6743913" y="588723"/>
            <a:ext cx="17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10nM BI4999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9836679" y="632750"/>
            <a:ext cx="17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0nM BI4999</a:t>
            </a:r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A2662B3B-14E4-491B-9E40-1102AD9DBD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384" y="1009365"/>
            <a:ext cx="2840445" cy="5723412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2E682AAD-F286-4621-A7B8-80AF23B214D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7045" y="1002082"/>
            <a:ext cx="2851067" cy="5744814"/>
          </a:xfrm>
          <a:prstGeom prst="rect">
            <a:avLst/>
          </a:prstGeom>
        </p:spPr>
      </p:pic>
      <p:pic>
        <p:nvPicPr>
          <p:cNvPr id="17" name="Grafik 16" descr="Ein Bild, das Tastatur, schließen enthält.&#10;&#10;Automatisch generierte Beschreibung">
            <a:extLst>
              <a:ext uri="{FF2B5EF4-FFF2-40B4-BE49-F238E27FC236}">
                <a16:creationId xmlns:a16="http://schemas.microsoft.com/office/drawing/2014/main" id="{B9CEF3ED-16FE-4E8B-A422-8C0E9810023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9328" y="1002082"/>
            <a:ext cx="2851067" cy="5744814"/>
          </a:xfrm>
          <a:prstGeom prst="rect">
            <a:avLst/>
          </a:prstGeom>
        </p:spPr>
      </p:pic>
      <p:pic>
        <p:nvPicPr>
          <p:cNvPr id="19" name="Grafik 18" descr="Ein Bild, das Nachthimmel enthält.&#10;&#10;Automatisch generierte Beschreibung">
            <a:extLst>
              <a:ext uri="{FF2B5EF4-FFF2-40B4-BE49-F238E27FC236}">
                <a16:creationId xmlns:a16="http://schemas.microsoft.com/office/drawing/2014/main" id="{132B05F2-680E-444C-93E4-AAB36CD79AB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31611" y="987962"/>
            <a:ext cx="2851067" cy="574481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AD14446-D375-4DFB-8026-97809FAB9DDB}"/>
              </a:ext>
            </a:extLst>
          </p:cNvPr>
          <p:cNvSpPr txBox="1"/>
          <p:nvPr/>
        </p:nvSpPr>
        <p:spPr>
          <a:xfrm>
            <a:off x="293863" y="-6198"/>
            <a:ext cx="2045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4 C</a:t>
            </a:r>
          </a:p>
        </p:txBody>
      </p:sp>
    </p:spTree>
    <p:extLst>
      <p:ext uri="{BB962C8B-B14F-4D97-AF65-F5344CB8AC3E}">
        <p14:creationId xmlns:p14="http://schemas.microsoft.com/office/powerpoint/2010/main" val="38448597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9F7BF7A-CBCD-4553-B909-822277952C17}"/>
              </a:ext>
            </a:extLst>
          </p:cNvPr>
          <p:cNvSpPr txBox="1"/>
          <p:nvPr/>
        </p:nvSpPr>
        <p:spPr>
          <a:xfrm flipH="1">
            <a:off x="5373369" y="111159"/>
            <a:ext cx="3042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/>
              <a:t>NC Ty-82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0EDCD69C-8E99-47EF-B3D1-E60422EB96C6}"/>
              </a:ext>
            </a:extLst>
          </p:cNvPr>
          <p:cNvSpPr txBox="1"/>
          <p:nvPr/>
        </p:nvSpPr>
        <p:spPr>
          <a:xfrm flipH="1">
            <a:off x="1093469" y="676645"/>
            <a:ext cx="1316356" cy="378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dirty="0"/>
              <a:t>control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D97E3F4-3D4C-4080-B45F-89156E58FDF4}"/>
              </a:ext>
            </a:extLst>
          </p:cNvPr>
          <p:cNvSpPr txBox="1"/>
          <p:nvPr/>
        </p:nvSpPr>
        <p:spPr>
          <a:xfrm flipH="1">
            <a:off x="3603858" y="686538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dirty="0"/>
              <a:t>1h  100nM NEO2734 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CFE8FDD4-AE58-4102-B3D6-660A4DA84B3A}"/>
              </a:ext>
            </a:extLst>
          </p:cNvPr>
          <p:cNvSpPr txBox="1"/>
          <p:nvPr/>
        </p:nvSpPr>
        <p:spPr>
          <a:xfrm flipH="1">
            <a:off x="6575657" y="696063"/>
            <a:ext cx="2246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dirty="0"/>
              <a:t>1h 300nM NEO2734 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651DF95C-09E4-4931-BEC1-AC496EEB2B04}"/>
              </a:ext>
            </a:extLst>
          </p:cNvPr>
          <p:cNvSpPr txBox="1"/>
          <p:nvPr/>
        </p:nvSpPr>
        <p:spPr>
          <a:xfrm flipH="1">
            <a:off x="9452207" y="715113"/>
            <a:ext cx="2246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dirty="0"/>
              <a:t>1h 1000nM NEO2734 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A7F95A97-D2EB-40A5-A665-B0AC61FB5F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300" y="1041492"/>
            <a:ext cx="2827125" cy="5683158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073985A1-16DD-4435-A631-BEA73CEDD2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4100" y="1041492"/>
            <a:ext cx="2827125" cy="5683158"/>
          </a:xfrm>
          <a:prstGeom prst="rect">
            <a:avLst/>
          </a:prstGeom>
        </p:spPr>
      </p:pic>
      <p:pic>
        <p:nvPicPr>
          <p:cNvPr id="14" name="Grafik 13" descr="Ein Bild, das Computer, Tastatur, haltend, Monitor enthält.&#10;&#10;Automatisch generierte Beschreibung">
            <a:extLst>
              <a:ext uri="{FF2B5EF4-FFF2-40B4-BE49-F238E27FC236}">
                <a16:creationId xmlns:a16="http://schemas.microsoft.com/office/drawing/2014/main" id="{E68ECBED-C95D-4992-866A-77B8647A26F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41492"/>
            <a:ext cx="2827125" cy="5683158"/>
          </a:xfrm>
          <a:prstGeom prst="rect">
            <a:avLst/>
          </a:prstGeom>
        </p:spPr>
      </p:pic>
      <p:pic>
        <p:nvPicPr>
          <p:cNvPr id="16" name="Grafik 15" descr="Ein Bild, das Blume, Stern enthält.&#10;&#10;Automatisch generierte Beschreibung">
            <a:extLst>
              <a:ext uri="{FF2B5EF4-FFF2-40B4-BE49-F238E27FC236}">
                <a16:creationId xmlns:a16="http://schemas.microsoft.com/office/drawing/2014/main" id="{46D20610-D6FB-4A42-B7D4-F115F5AEFDD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9555" y="1041492"/>
            <a:ext cx="2827125" cy="568315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77F79FF-C9E7-4D2B-9DE9-14553EA45183}"/>
              </a:ext>
            </a:extLst>
          </p:cNvPr>
          <p:cNvSpPr txBox="1"/>
          <p:nvPr/>
        </p:nvSpPr>
        <p:spPr>
          <a:xfrm>
            <a:off x="292323" y="181009"/>
            <a:ext cx="20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4 D</a:t>
            </a:r>
          </a:p>
        </p:txBody>
      </p:sp>
    </p:spTree>
    <p:extLst>
      <p:ext uri="{BB962C8B-B14F-4D97-AF65-F5344CB8AC3E}">
        <p14:creationId xmlns:p14="http://schemas.microsoft.com/office/powerpoint/2010/main" val="5014870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130569" y="551143"/>
            <a:ext cx="850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control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3523292" y="551143"/>
            <a:ext cx="2090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100nM CCS-1477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6545065" y="563671"/>
            <a:ext cx="2073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300nM CCS-1477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9490696" y="551141"/>
            <a:ext cx="2207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1h 1000nM CCS-1477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35" y="933003"/>
            <a:ext cx="2926238" cy="5896281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5492" y="933001"/>
            <a:ext cx="2926238" cy="5896281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449" y="933001"/>
            <a:ext cx="2926237" cy="5896281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1405" y="933001"/>
            <a:ext cx="2926238" cy="589628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E6AEA98-5D2F-48AF-8E44-4AAE640BABBE}"/>
              </a:ext>
            </a:extLst>
          </p:cNvPr>
          <p:cNvSpPr txBox="1"/>
          <p:nvPr/>
        </p:nvSpPr>
        <p:spPr>
          <a:xfrm>
            <a:off x="293863" y="38876"/>
            <a:ext cx="2034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4 E</a:t>
            </a:r>
          </a:p>
        </p:txBody>
      </p:sp>
      <p:sp>
        <p:nvSpPr>
          <p:cNvPr id="13" name="Textfeld 3">
            <a:extLst>
              <a:ext uri="{FF2B5EF4-FFF2-40B4-BE49-F238E27FC236}">
                <a16:creationId xmlns:a16="http://schemas.microsoft.com/office/drawing/2014/main" id="{41008EF4-9CE2-4A37-B885-1BFB9874B7B6}"/>
              </a:ext>
            </a:extLst>
          </p:cNvPr>
          <p:cNvSpPr txBox="1"/>
          <p:nvPr/>
        </p:nvSpPr>
        <p:spPr>
          <a:xfrm flipH="1">
            <a:off x="5373369" y="169285"/>
            <a:ext cx="3042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b="1" dirty="0"/>
              <a:t>NC Ty-82</a:t>
            </a:r>
          </a:p>
        </p:txBody>
      </p:sp>
    </p:spTree>
    <p:extLst>
      <p:ext uri="{BB962C8B-B14F-4D97-AF65-F5344CB8AC3E}">
        <p14:creationId xmlns:p14="http://schemas.microsoft.com/office/powerpoint/2010/main" val="5334901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41F83F2-A5A0-4547-A881-B219043D29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882" y="1722616"/>
            <a:ext cx="1638000" cy="163316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6245159-BF79-4777-B396-A9F4C9280A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43666" y="1713588"/>
            <a:ext cx="1634468" cy="163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BC4919F-2DC9-48AB-95DC-7C246C6BC84C}"/>
              </a:ext>
            </a:extLst>
          </p:cNvPr>
          <p:cNvSpPr txBox="1"/>
          <p:nvPr/>
        </p:nvSpPr>
        <p:spPr>
          <a:xfrm>
            <a:off x="1250137" y="1273860"/>
            <a:ext cx="13592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/>
              <a:t>control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10DBBC4-2EA6-465A-9FA7-E6AEEC2A42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94234" y="1713775"/>
            <a:ext cx="1638000" cy="163316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0F20629-E39D-48C7-9A48-5DD8A1C4FA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32582" y="1713588"/>
            <a:ext cx="1712366" cy="163335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774E432-5B12-4D40-9EF8-F22E28A423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34500" y="1722429"/>
            <a:ext cx="1648796" cy="16333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4977293-6561-49C7-A58B-25FD1A6A8103}"/>
              </a:ext>
            </a:extLst>
          </p:cNvPr>
          <p:cNvSpPr txBox="1"/>
          <p:nvPr/>
        </p:nvSpPr>
        <p:spPr>
          <a:xfrm>
            <a:off x="4371348" y="1344256"/>
            <a:ext cx="13837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30 nM </a:t>
            </a:r>
            <a:r>
              <a:rPr lang="de-AT" sz="1400" dirty="0">
                <a:sym typeface="Wingdings" panose="05000000000000000000" pitchFamily="2" charset="2"/>
              </a:rPr>
              <a:t> 10 nM</a:t>
            </a:r>
            <a:endParaRPr lang="de-AT" sz="1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BCA48F4-C80D-4046-BDF2-F97289576B8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19727" y="1722429"/>
            <a:ext cx="1665487" cy="163335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4816FC8-954E-45DC-B4AF-7BE9CE11A476}"/>
              </a:ext>
            </a:extLst>
          </p:cNvPr>
          <p:cNvSpPr txBox="1"/>
          <p:nvPr/>
        </p:nvSpPr>
        <p:spPr>
          <a:xfrm>
            <a:off x="2609362" y="1344256"/>
            <a:ext cx="1346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30 nM (60 min)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94E9362-DD5D-405F-9D4F-8CB6B7947346}"/>
              </a:ext>
            </a:extLst>
          </p:cNvPr>
          <p:cNvSpPr txBox="1"/>
          <p:nvPr/>
        </p:nvSpPr>
        <p:spPr>
          <a:xfrm>
            <a:off x="6296909" y="1344256"/>
            <a:ext cx="12923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30 nM </a:t>
            </a:r>
            <a:r>
              <a:rPr lang="de-AT" sz="1400" dirty="0">
                <a:sym typeface="Wingdings" panose="05000000000000000000" pitchFamily="2" charset="2"/>
              </a:rPr>
              <a:t> 5 nM</a:t>
            </a:r>
            <a:endParaRPr lang="de-AT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EA1BCF4-0E3A-414B-889A-B2B80C5A50F9}"/>
              </a:ext>
            </a:extLst>
          </p:cNvPr>
          <p:cNvSpPr txBox="1"/>
          <p:nvPr/>
        </p:nvSpPr>
        <p:spPr>
          <a:xfrm>
            <a:off x="8131099" y="1353284"/>
            <a:ext cx="1428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30 nM </a:t>
            </a:r>
            <a:r>
              <a:rPr lang="de-AT" sz="1400" dirty="0">
                <a:sym typeface="Wingdings" panose="05000000000000000000" pitchFamily="2" charset="2"/>
              </a:rPr>
              <a:t> 2.5 nM</a:t>
            </a:r>
            <a:endParaRPr lang="de-AT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211D1C6-28F6-4940-8466-F47E1D8F3D2F}"/>
              </a:ext>
            </a:extLst>
          </p:cNvPr>
          <p:cNvSpPr txBox="1"/>
          <p:nvPr/>
        </p:nvSpPr>
        <p:spPr>
          <a:xfrm>
            <a:off x="9846602" y="1344069"/>
            <a:ext cx="12923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400" dirty="0"/>
              <a:t>30 nM </a:t>
            </a:r>
            <a:r>
              <a:rPr lang="de-AT" sz="1400" dirty="0">
                <a:sym typeface="Wingdings" panose="05000000000000000000" pitchFamily="2" charset="2"/>
              </a:rPr>
              <a:t> 0 nM</a:t>
            </a:r>
            <a:endParaRPr lang="de-AT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6C683B5-384D-4F81-8C78-A87B8FF42D74}"/>
              </a:ext>
            </a:extLst>
          </p:cNvPr>
          <p:cNvSpPr txBox="1"/>
          <p:nvPr/>
        </p:nvSpPr>
        <p:spPr>
          <a:xfrm>
            <a:off x="247210" y="204513"/>
            <a:ext cx="18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Supplement Fig. 5</a:t>
            </a:r>
          </a:p>
        </p:txBody>
      </p:sp>
    </p:spTree>
    <p:extLst>
      <p:ext uri="{BB962C8B-B14F-4D97-AF65-F5344CB8AC3E}">
        <p14:creationId xmlns:p14="http://schemas.microsoft.com/office/powerpoint/2010/main" val="1105495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BI Theme Colors Top">
    <a:dk1>
      <a:sysClr val="windowText" lastClr="000000"/>
    </a:dk1>
    <a:lt1>
      <a:sysClr val="window" lastClr="FFFFFF"/>
    </a:lt1>
    <a:dk2>
      <a:srgbClr val="336699"/>
    </a:dk2>
    <a:lt2>
      <a:srgbClr val="FFFFFF"/>
    </a:lt2>
    <a:accent1>
      <a:srgbClr val="003366"/>
    </a:accent1>
    <a:accent2>
      <a:srgbClr val="336699"/>
    </a:accent2>
    <a:accent3>
      <a:srgbClr val="6699CC"/>
    </a:accent3>
    <a:accent4>
      <a:srgbClr val="CC3333"/>
    </a:accent4>
    <a:accent5>
      <a:srgbClr val="669999"/>
    </a:accent5>
    <a:accent6>
      <a:srgbClr val="999900"/>
    </a:accent6>
    <a:hlink>
      <a:srgbClr val="0066CC"/>
    </a:hlink>
    <a:folHlink>
      <a:srgbClr val="FF9900"/>
    </a:folHlink>
  </a:clrScheme>
  <a:fontScheme name="BI Designfont">
    <a:majorFont>
      <a:latin typeface="BISansCond"/>
      <a:ea typeface=""/>
      <a:cs typeface=""/>
    </a:majorFont>
    <a:minorFont>
      <a:latin typeface="BISans"/>
      <a:ea typeface=""/>
      <a:cs typeface="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2</Words>
  <Application>Microsoft Office PowerPoint</Application>
  <PresentationFormat>Widescreen</PresentationFormat>
  <Paragraphs>310</Paragraphs>
  <Slides>1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6" baseType="lpstr">
      <vt:lpstr>Arial</vt:lpstr>
      <vt:lpstr>BISans</vt:lpstr>
      <vt:lpstr>BISansCond</vt:lpstr>
      <vt:lpstr>BISansOpti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ntsch-Grunt,Dr.,Ulrike (RES CancerR) BIG-AT-V</dc:creator>
  <cp:lastModifiedBy>Tontsch-Grunt,Dr.,Ulrike (RES CancerR) BIG-AT-V</cp:lastModifiedBy>
  <cp:revision>2</cp:revision>
  <dcterms:created xsi:type="dcterms:W3CDTF">2022-03-10T18:23:21Z</dcterms:created>
  <dcterms:modified xsi:type="dcterms:W3CDTF">2022-03-10T18:33:00Z</dcterms:modified>
</cp:coreProperties>
</file>